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4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324" r:id="rId2"/>
    <p:sldId id="306" r:id="rId3"/>
    <p:sldId id="318" r:id="rId4"/>
    <p:sldId id="330" r:id="rId5"/>
    <p:sldId id="320" r:id="rId6"/>
    <p:sldId id="321" r:id="rId7"/>
    <p:sldId id="325" r:id="rId8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0178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Style moyen 3 - Accentuation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202B0CA-FC54-4496-8BCA-5EF66A818D29}" styleName="Style foncé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2833802-FEF1-4C79-8D5D-14CF1EAF98D9}" styleName="Style léger 2 - Accentuation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B301B821-A1FF-4177-AEE7-76D212191A09}" styleName="Style moyen 1 - Accentuatio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031"/>
    <p:restoredTop sz="86531"/>
  </p:normalViewPr>
  <p:slideViewPr>
    <p:cSldViewPr snapToGrid="0" snapToObjects="1">
      <p:cViewPr varScale="1">
        <p:scale>
          <a:sx n="110" d="100"/>
          <a:sy n="110" d="100"/>
        </p:scale>
        <p:origin x="1528" y="1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causse/Desktop/Invite%20MS%20mars26/Supp%20Tab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causse/Desktop/Invite%20MS%20mars26/Supp%20Tabl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causse/Desktop/Invite%20MS%20mars26/Supp%20Tabl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mcausse/a%20a%20Projets%20de%20recherche/2019%20H2020%20INVITE/new_gapit/GAPIT_all/Gapit_all_out/GAPIT.GLM.TimeMaturity.PRED.csv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mcausse/a%20a%20Projets%20de%20recherche/2019%20H2020%20INVITE/new_gapit/GAPIT_all/Gapit_all_out/GAPIT.MLM.TimeFflowering.PRED.csv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mcausse/a%20a%20Projets%20de%20recherche/2019%20H2020%20INVITE/new_gapit/GAPIT_all/Gapit_all_out/GAPIT.MLM.TimeMaturity.PRED.csv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%</a:t>
            </a:r>
            <a:r>
              <a:rPr lang="fr-FR" baseline="0"/>
              <a:t> Heterozygous</a:t>
            </a:r>
            <a:endParaRPr lang="fr-FR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view3D>
      <c:rotX val="25"/>
      <c:rotY val="20"/>
      <c:depthPercent val="15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line3DChart>
        <c:grouping val="standard"/>
        <c:varyColors val="0"/>
        <c:ser>
          <c:idx val="0"/>
          <c:order val="0"/>
          <c:tx>
            <c:strRef>
              <c:f>'5_He htz MAF NA '!$H$18</c:f>
              <c:strCache>
                <c:ptCount val="1"/>
                <c:pt idx="0">
                  <c:v>B199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cat>
            <c:strRef>
              <c:f>'5_He htz MAF NA '!$G$19:$G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H$19:$H$30</c:f>
              <c:numCache>
                <c:formatCode>_(* #,##0.00_);_(* \(#,##0.00\);_(* "-"??_);_(@_)</c:formatCode>
                <c:ptCount val="12"/>
                <c:pt idx="0">
                  <c:v>0.19942151922055135</c:v>
                </c:pt>
                <c:pt idx="1">
                  <c:v>9.1064590495655962E-2</c:v>
                </c:pt>
                <c:pt idx="2">
                  <c:v>0.21115459813714366</c:v>
                </c:pt>
                <c:pt idx="3">
                  <c:v>4.9339464682900638E-2</c:v>
                </c:pt>
                <c:pt idx="4">
                  <c:v>1.9604783154465354E-2</c:v>
                </c:pt>
                <c:pt idx="5">
                  <c:v>0.11132025943792444</c:v>
                </c:pt>
                <c:pt idx="6">
                  <c:v>0.14273399203364082</c:v>
                </c:pt>
                <c:pt idx="7">
                  <c:v>0.22688187063447007</c:v>
                </c:pt>
                <c:pt idx="8">
                  <c:v>0.13033385720900179</c:v>
                </c:pt>
                <c:pt idx="9">
                  <c:v>0.250065176475605</c:v>
                </c:pt>
                <c:pt idx="10">
                  <c:v>5.9535586629590478E-2</c:v>
                </c:pt>
                <c:pt idx="11">
                  <c:v>0.16783823438649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A8C-0A40-8CE5-93192FD735C1}"/>
            </c:ext>
          </c:extLst>
        </c:ser>
        <c:ser>
          <c:idx val="1"/>
          <c:order val="1"/>
          <c:tx>
            <c:strRef>
              <c:f>'5_He htz MAF NA '!$I$18</c:f>
              <c:strCache>
                <c:ptCount val="1"/>
                <c:pt idx="0">
                  <c:v>B200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cat>
            <c:strRef>
              <c:f>'5_He htz MAF NA '!$G$19:$G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I$19:$I$30</c:f>
              <c:numCache>
                <c:formatCode>_(* #,##0.00_);_(* \(#,##0.00\);_(* "-"??_);_(@_)</c:formatCode>
                <c:ptCount val="12"/>
                <c:pt idx="0">
                  <c:v>0.27515875530159184</c:v>
                </c:pt>
                <c:pt idx="1">
                  <c:v>0.19253311859623218</c:v>
                </c:pt>
                <c:pt idx="2">
                  <c:v>0.24884657281494518</c:v>
                </c:pt>
                <c:pt idx="3">
                  <c:v>0.16248246148015844</c:v>
                </c:pt>
                <c:pt idx="4">
                  <c:v>0.2485657372176045</c:v>
                </c:pt>
                <c:pt idx="5">
                  <c:v>0.15566834587975278</c:v>
                </c:pt>
                <c:pt idx="6">
                  <c:v>0.27079170792200219</c:v>
                </c:pt>
                <c:pt idx="7">
                  <c:v>0.26042842541343386</c:v>
                </c:pt>
                <c:pt idx="8">
                  <c:v>0.22896634702750993</c:v>
                </c:pt>
                <c:pt idx="9">
                  <c:v>0.31650431919463934</c:v>
                </c:pt>
                <c:pt idx="10">
                  <c:v>0.25983780127884937</c:v>
                </c:pt>
                <c:pt idx="11">
                  <c:v>0.195414666772183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A8C-0A40-8CE5-93192FD735C1}"/>
            </c:ext>
          </c:extLst>
        </c:ser>
        <c:ser>
          <c:idx val="2"/>
          <c:order val="2"/>
          <c:tx>
            <c:strRef>
              <c:f>'5_He htz MAF NA '!$J$18</c:f>
              <c:strCache>
                <c:ptCount val="1"/>
                <c:pt idx="0">
                  <c:v>B2010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cat>
            <c:strRef>
              <c:f>'5_He htz MAF NA '!$G$19:$G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J$19:$J$30</c:f>
              <c:numCache>
                <c:formatCode>_(* #,##0.00_);_(* \(#,##0.00\);_(* "-"??_);_(@_)</c:formatCode>
                <c:ptCount val="12"/>
                <c:pt idx="0">
                  <c:v>0.29079473750704155</c:v>
                </c:pt>
                <c:pt idx="1">
                  <c:v>0.18567137358865884</c:v>
                </c:pt>
                <c:pt idx="2">
                  <c:v>0.26387442319210719</c:v>
                </c:pt>
                <c:pt idx="3">
                  <c:v>0.21821338481025926</c:v>
                </c:pt>
                <c:pt idx="4">
                  <c:v>0.23621717426732952</c:v>
                </c:pt>
                <c:pt idx="5">
                  <c:v>0.17764634000892335</c:v>
                </c:pt>
                <c:pt idx="6">
                  <c:v>0.27683862823501709</c:v>
                </c:pt>
                <c:pt idx="7">
                  <c:v>0.2885441597855013</c:v>
                </c:pt>
                <c:pt idx="8">
                  <c:v>0.28204591576124172</c:v>
                </c:pt>
                <c:pt idx="9">
                  <c:v>0.3376472213918118</c:v>
                </c:pt>
                <c:pt idx="10">
                  <c:v>0.30889642569429965</c:v>
                </c:pt>
                <c:pt idx="11">
                  <c:v>0.204975018536262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A8C-0A40-8CE5-93192FD735C1}"/>
            </c:ext>
          </c:extLst>
        </c:ser>
        <c:ser>
          <c:idx val="3"/>
          <c:order val="3"/>
          <c:tx>
            <c:strRef>
              <c:f>'5_He htz MAF NA '!$K$18</c:f>
              <c:strCache>
                <c:ptCount val="1"/>
                <c:pt idx="0">
                  <c:v>B202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cat>
            <c:strRef>
              <c:f>'5_He htz MAF NA '!$G$19:$G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K$19:$K$30</c:f>
              <c:numCache>
                <c:formatCode>_(* #,##0.00_);_(* \(#,##0.00\);_(* "-"??_);_(@_)</c:formatCode>
                <c:ptCount val="12"/>
                <c:pt idx="0">
                  <c:v>0.30352354512827284</c:v>
                </c:pt>
                <c:pt idx="1">
                  <c:v>0.18971995791916269</c:v>
                </c:pt>
                <c:pt idx="2">
                  <c:v>0.22549685268865211</c:v>
                </c:pt>
                <c:pt idx="3">
                  <c:v>0.22162364476848836</c:v>
                </c:pt>
                <c:pt idx="4">
                  <c:v>0.24099081182467988</c:v>
                </c:pt>
                <c:pt idx="5">
                  <c:v>0.1737284107750097</c:v>
                </c:pt>
                <c:pt idx="6">
                  <c:v>0.29694347116558872</c:v>
                </c:pt>
                <c:pt idx="7">
                  <c:v>0.28540127949272642</c:v>
                </c:pt>
                <c:pt idx="8">
                  <c:v>0.28587484806776764</c:v>
                </c:pt>
                <c:pt idx="9">
                  <c:v>0.33260589412608171</c:v>
                </c:pt>
                <c:pt idx="10">
                  <c:v>0.29585942583409042</c:v>
                </c:pt>
                <c:pt idx="11">
                  <c:v>0.245093860272329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A8C-0A40-8CE5-93192FD735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45007407"/>
        <c:axId val="23771808"/>
        <c:axId val="2139760943"/>
      </c:line3DChart>
      <c:catAx>
        <c:axId val="174500740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3771808"/>
        <c:crosses val="autoZero"/>
        <c:auto val="1"/>
        <c:lblAlgn val="ctr"/>
        <c:lblOffset val="100"/>
        <c:noMultiLvlLbl val="0"/>
      </c:catAx>
      <c:valAx>
        <c:axId val="237718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_(* #,##0.00_);_(* \(#,##0.00\);_(* &quot;-&quot;??_);_(@_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45007407"/>
        <c:crosses val="autoZero"/>
        <c:crossBetween val="between"/>
      </c:valAx>
      <c:serAx>
        <c:axId val="2139760943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3771808"/>
        <c:crosses val="autoZero"/>
      </c:ser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MAF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view3D>
      <c:rotX val="25"/>
      <c:rotY val="20"/>
      <c:depthPercent val="15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line3DChart>
        <c:grouping val="standard"/>
        <c:varyColors val="0"/>
        <c:ser>
          <c:idx val="0"/>
          <c:order val="0"/>
          <c:tx>
            <c:strRef>
              <c:f>'5_He htz MAF NA '!$M$18</c:f>
              <c:strCache>
                <c:ptCount val="1"/>
                <c:pt idx="0">
                  <c:v>B199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cat>
            <c:strRef>
              <c:f>'5_He htz MAF NA '!$L$19:$L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M$19:$M$30</c:f>
              <c:numCache>
                <c:formatCode>_(* #,##0.00_);_(* \(#,##0.00\);_(* "-"??_);_(@_)</c:formatCode>
                <c:ptCount val="12"/>
                <c:pt idx="0">
                  <c:v>0.17791376666630696</c:v>
                </c:pt>
                <c:pt idx="1">
                  <c:v>0.11614791137589672</c:v>
                </c:pt>
                <c:pt idx="2">
                  <c:v>0.24473248607603101</c:v>
                </c:pt>
                <c:pt idx="3">
                  <c:v>4.7983466042884428E-2</c:v>
                </c:pt>
                <c:pt idx="4">
                  <c:v>2.3179168647284899E-2</c:v>
                </c:pt>
                <c:pt idx="5">
                  <c:v>0.10132968375028498</c:v>
                </c:pt>
                <c:pt idx="6">
                  <c:v>0.20846153069318743</c:v>
                </c:pt>
                <c:pt idx="7">
                  <c:v>0.21063274887670672</c:v>
                </c:pt>
                <c:pt idx="8">
                  <c:v>0.12488171431729028</c:v>
                </c:pt>
                <c:pt idx="9">
                  <c:v>0.25539438309617785</c:v>
                </c:pt>
                <c:pt idx="10">
                  <c:v>4.3693010014240037E-2</c:v>
                </c:pt>
                <c:pt idx="11">
                  <c:v>0.145279488056135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378-A145-95FD-E5C936F631A1}"/>
            </c:ext>
          </c:extLst>
        </c:ser>
        <c:ser>
          <c:idx val="1"/>
          <c:order val="1"/>
          <c:tx>
            <c:strRef>
              <c:f>'5_He htz MAF NA '!$N$18</c:f>
              <c:strCache>
                <c:ptCount val="1"/>
                <c:pt idx="0">
                  <c:v>B200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cat>
            <c:strRef>
              <c:f>'5_He htz MAF NA '!$L$19:$L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N$19:$N$30</c:f>
              <c:numCache>
                <c:formatCode>_(* #,##0.00_);_(* \(#,##0.00\);_(* "-"??_);_(@_)</c:formatCode>
                <c:ptCount val="12"/>
                <c:pt idx="0">
                  <c:v>0.25566316452946469</c:v>
                </c:pt>
                <c:pt idx="1">
                  <c:v>0.20329339074354275</c:v>
                </c:pt>
                <c:pt idx="2">
                  <c:v>0.20598390986747059</c:v>
                </c:pt>
                <c:pt idx="3">
                  <c:v>0.23221370817000858</c:v>
                </c:pt>
                <c:pt idx="4">
                  <c:v>0.31616002360669915</c:v>
                </c:pt>
                <c:pt idx="5">
                  <c:v>0.1627347759974947</c:v>
                </c:pt>
                <c:pt idx="6">
                  <c:v>0.2797654797309308</c:v>
                </c:pt>
                <c:pt idx="7">
                  <c:v>0.22925918828846481</c:v>
                </c:pt>
                <c:pt idx="8">
                  <c:v>0.23044960883188276</c:v>
                </c:pt>
                <c:pt idx="9">
                  <c:v>0.28458687151533124</c:v>
                </c:pt>
                <c:pt idx="10">
                  <c:v>0.3035428282903867</c:v>
                </c:pt>
                <c:pt idx="11">
                  <c:v>0.255015607432954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378-A145-95FD-E5C936F631A1}"/>
            </c:ext>
          </c:extLst>
        </c:ser>
        <c:ser>
          <c:idx val="2"/>
          <c:order val="2"/>
          <c:tx>
            <c:strRef>
              <c:f>'5_He htz MAF NA '!$O$18</c:f>
              <c:strCache>
                <c:ptCount val="1"/>
                <c:pt idx="0">
                  <c:v>B2010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cat>
            <c:strRef>
              <c:f>'5_He htz MAF NA '!$L$19:$L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O$19:$O$30</c:f>
              <c:numCache>
                <c:formatCode>_(* #,##0.00_);_(* \(#,##0.00\);_(* "-"??_);_(@_)</c:formatCode>
                <c:ptCount val="12"/>
                <c:pt idx="0">
                  <c:v>0.2420231489006581</c:v>
                </c:pt>
                <c:pt idx="1">
                  <c:v>0.1999240901487391</c:v>
                </c:pt>
                <c:pt idx="2">
                  <c:v>0.18888797367539475</c:v>
                </c:pt>
                <c:pt idx="3">
                  <c:v>0.20372478902566474</c:v>
                </c:pt>
                <c:pt idx="4">
                  <c:v>0.26889441245676421</c:v>
                </c:pt>
                <c:pt idx="5">
                  <c:v>0.14466012406876272</c:v>
                </c:pt>
                <c:pt idx="6">
                  <c:v>0.27242991946998646</c:v>
                </c:pt>
                <c:pt idx="7">
                  <c:v>0.21356490923522309</c:v>
                </c:pt>
                <c:pt idx="8">
                  <c:v>0.25972898655315368</c:v>
                </c:pt>
                <c:pt idx="9">
                  <c:v>0.29313786175859419</c:v>
                </c:pt>
                <c:pt idx="10">
                  <c:v>0.2874418246339534</c:v>
                </c:pt>
                <c:pt idx="11">
                  <c:v>0.220593957236665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378-A145-95FD-E5C936F631A1}"/>
            </c:ext>
          </c:extLst>
        </c:ser>
        <c:ser>
          <c:idx val="3"/>
          <c:order val="3"/>
          <c:tx>
            <c:strRef>
              <c:f>'5_He htz MAF NA '!$P$18</c:f>
              <c:strCache>
                <c:ptCount val="1"/>
                <c:pt idx="0">
                  <c:v>B202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cat>
            <c:strRef>
              <c:f>'5_He htz MAF NA '!$L$19:$L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P$19:$P$30</c:f>
              <c:numCache>
                <c:formatCode>_(* #,##0.00_);_(* \(#,##0.00\);_(* "-"??_);_(@_)</c:formatCode>
                <c:ptCount val="12"/>
                <c:pt idx="0">
                  <c:v>0.28137661514439488</c:v>
                </c:pt>
                <c:pt idx="1">
                  <c:v>0.23068879883102353</c:v>
                </c:pt>
                <c:pt idx="2">
                  <c:v>0.20143237391131305</c:v>
                </c:pt>
                <c:pt idx="3">
                  <c:v>0.2954943879361196</c:v>
                </c:pt>
                <c:pt idx="4">
                  <c:v>0.3584344009916311</c:v>
                </c:pt>
                <c:pt idx="5">
                  <c:v>0.17607288819944242</c:v>
                </c:pt>
                <c:pt idx="6">
                  <c:v>0.27066230289107734</c:v>
                </c:pt>
                <c:pt idx="7">
                  <c:v>0.22858137897492112</c:v>
                </c:pt>
                <c:pt idx="8">
                  <c:v>0.27336039899731618</c:v>
                </c:pt>
                <c:pt idx="9">
                  <c:v>0.30875532425349023</c:v>
                </c:pt>
                <c:pt idx="10">
                  <c:v>0.34280670574349947</c:v>
                </c:pt>
                <c:pt idx="11">
                  <c:v>0.248904286473580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378-A145-95FD-E5C936F631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428880"/>
        <c:axId val="933651600"/>
        <c:axId val="24880944"/>
      </c:line3DChart>
      <c:catAx>
        <c:axId val="22428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33651600"/>
        <c:crosses val="autoZero"/>
        <c:auto val="1"/>
        <c:lblAlgn val="ctr"/>
        <c:lblOffset val="100"/>
        <c:noMultiLvlLbl val="0"/>
      </c:catAx>
      <c:valAx>
        <c:axId val="9336516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_(* #,##0.00_);_(* \(#,##0.00\);_(* &quot;-&quot;??_);_(@_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2428880"/>
        <c:crosses val="autoZero"/>
        <c:crossBetween val="between"/>
      </c:valAx>
      <c:serAx>
        <c:axId val="2488094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33651600"/>
        <c:crosses val="autoZero"/>
      </c:ser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N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view3D>
      <c:rotX val="25"/>
      <c:rotY val="20"/>
      <c:depthPercent val="15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line3DChart>
        <c:grouping val="standard"/>
        <c:varyColors val="0"/>
        <c:ser>
          <c:idx val="0"/>
          <c:order val="0"/>
          <c:tx>
            <c:strRef>
              <c:f>'5_He htz MAF NA '!$R$18</c:f>
              <c:strCache>
                <c:ptCount val="1"/>
                <c:pt idx="0">
                  <c:v>B199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cat>
            <c:strRef>
              <c:f>'5_He htz MAF NA '!$Q$19:$Q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R$19:$R$30</c:f>
              <c:numCache>
                <c:formatCode>_(* #,##0.00_);_(* \(#,##0.00\);_(* "-"??_);_(@_)</c:formatCode>
                <c:ptCount val="12"/>
                <c:pt idx="0">
                  <c:v>1.0605306799336649</c:v>
                </c:pt>
                <c:pt idx="1">
                  <c:v>0.68354430379746833</c:v>
                </c:pt>
                <c:pt idx="2">
                  <c:v>0.72207446808510634</c:v>
                </c:pt>
                <c:pt idx="3">
                  <c:v>1.2969696969696969</c:v>
                </c:pt>
                <c:pt idx="4">
                  <c:v>1.6506996770721205</c:v>
                </c:pt>
                <c:pt idx="5">
                  <c:v>0.39867109634551495</c:v>
                </c:pt>
                <c:pt idx="6">
                  <c:v>0.8818770226537217</c:v>
                </c:pt>
                <c:pt idx="7">
                  <c:v>2.5348258706467663</c:v>
                </c:pt>
                <c:pt idx="8">
                  <c:v>1.2412314886983633</c:v>
                </c:pt>
                <c:pt idx="9">
                  <c:v>0.79350348027842232</c:v>
                </c:pt>
                <c:pt idx="10">
                  <c:v>1.6120290812954394</c:v>
                </c:pt>
                <c:pt idx="11">
                  <c:v>1.49033505154639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17D-EC48-84F1-B0F5DC16443C}"/>
            </c:ext>
          </c:extLst>
        </c:ser>
        <c:ser>
          <c:idx val="1"/>
          <c:order val="1"/>
          <c:tx>
            <c:strRef>
              <c:f>'5_He htz MAF NA '!$S$18</c:f>
              <c:strCache>
                <c:ptCount val="1"/>
                <c:pt idx="0">
                  <c:v>B200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cat>
            <c:strRef>
              <c:f>'5_He htz MAF NA '!$Q$19:$Q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S$19:$S$30</c:f>
              <c:numCache>
                <c:formatCode>_(* #,##0.00_);_(* \(#,##0.00\);_(* "-"??_);_(@_)</c:formatCode>
                <c:ptCount val="12"/>
                <c:pt idx="0">
                  <c:v>1.5572139303482586</c:v>
                </c:pt>
                <c:pt idx="1">
                  <c:v>0.96455696202531649</c:v>
                </c:pt>
                <c:pt idx="2">
                  <c:v>1.0890957446808511</c:v>
                </c:pt>
                <c:pt idx="3">
                  <c:v>2.0363236103467255</c:v>
                </c:pt>
                <c:pt idx="4">
                  <c:v>2.8471474703982778</c:v>
                </c:pt>
                <c:pt idx="5">
                  <c:v>0.81561461794019929</c:v>
                </c:pt>
                <c:pt idx="6">
                  <c:v>1.3317152103559871</c:v>
                </c:pt>
                <c:pt idx="7">
                  <c:v>3.7437810945273631</c:v>
                </c:pt>
                <c:pt idx="8">
                  <c:v>2.1223694466095089</c:v>
                </c:pt>
                <c:pt idx="9">
                  <c:v>1.111368909512761</c:v>
                </c:pt>
                <c:pt idx="10">
                  <c:v>2.5185185185185186</c:v>
                </c:pt>
                <c:pt idx="11">
                  <c:v>2.4027061855670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17D-EC48-84F1-B0F5DC16443C}"/>
            </c:ext>
          </c:extLst>
        </c:ser>
        <c:ser>
          <c:idx val="2"/>
          <c:order val="2"/>
          <c:tx>
            <c:strRef>
              <c:f>'5_He htz MAF NA '!$T$18</c:f>
              <c:strCache>
                <c:ptCount val="1"/>
                <c:pt idx="0">
                  <c:v>B2010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cat>
            <c:strRef>
              <c:f>'5_He htz MAF NA '!$Q$19:$Q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T$19:$T$30</c:f>
              <c:numCache>
                <c:formatCode>_(* #,##0.00_);_(* \(#,##0.00\);_(* "-"??_);_(@_)</c:formatCode>
                <c:ptCount val="12"/>
                <c:pt idx="0">
                  <c:v>3.8499170812603647</c:v>
                </c:pt>
                <c:pt idx="1">
                  <c:v>2.3924050632911391</c:v>
                </c:pt>
                <c:pt idx="2">
                  <c:v>2.7061170212765959</c:v>
                </c:pt>
                <c:pt idx="3">
                  <c:v>4.9658778205833789</c:v>
                </c:pt>
                <c:pt idx="4">
                  <c:v>6.8907427341227123</c:v>
                </c:pt>
                <c:pt idx="5">
                  <c:v>2.191029900332226</c:v>
                </c:pt>
                <c:pt idx="6">
                  <c:v>3.3883495145631066</c:v>
                </c:pt>
                <c:pt idx="7">
                  <c:v>9.3482587064676625</c:v>
                </c:pt>
                <c:pt idx="8">
                  <c:v>5.8199532346063911</c:v>
                </c:pt>
                <c:pt idx="9">
                  <c:v>2.8329466357308584</c:v>
                </c:pt>
                <c:pt idx="10">
                  <c:v>6.2009253139458034</c:v>
                </c:pt>
                <c:pt idx="11">
                  <c:v>5.88530927835051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17D-EC48-84F1-B0F5DC16443C}"/>
            </c:ext>
          </c:extLst>
        </c:ser>
        <c:ser>
          <c:idx val="3"/>
          <c:order val="3"/>
          <c:tx>
            <c:strRef>
              <c:f>'5_He htz MAF NA '!$U$18</c:f>
              <c:strCache>
                <c:ptCount val="1"/>
                <c:pt idx="0">
                  <c:v>B202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cat>
            <c:strRef>
              <c:f>'5_He htz MAF NA '!$Q$19:$Q$30</c:f>
              <c:strCache>
                <c:ptCount val="12"/>
                <c:pt idx="0">
                  <c:v>SL4ch01</c:v>
                </c:pt>
                <c:pt idx="1">
                  <c:v>SL4ch02</c:v>
                </c:pt>
                <c:pt idx="2">
                  <c:v>SL4ch03</c:v>
                </c:pt>
                <c:pt idx="3">
                  <c:v>SL4ch04</c:v>
                </c:pt>
                <c:pt idx="4">
                  <c:v>SL4ch05</c:v>
                </c:pt>
                <c:pt idx="5">
                  <c:v>SL4ch06</c:v>
                </c:pt>
                <c:pt idx="6">
                  <c:v>SL4ch07</c:v>
                </c:pt>
                <c:pt idx="7">
                  <c:v>SL4ch08</c:v>
                </c:pt>
                <c:pt idx="8">
                  <c:v>SL4ch09</c:v>
                </c:pt>
                <c:pt idx="9">
                  <c:v>SL4ch10</c:v>
                </c:pt>
                <c:pt idx="10">
                  <c:v>SL4ch11</c:v>
                </c:pt>
                <c:pt idx="11">
                  <c:v>SL4ch12</c:v>
                </c:pt>
              </c:strCache>
            </c:strRef>
          </c:cat>
          <c:val>
            <c:numRef>
              <c:f>'5_He htz MAF NA '!$U$19:$U$30</c:f>
              <c:numCache>
                <c:formatCode>_(* #,##0.00_);_(* \(#,##0.00\);_(* "-"??_);_(@_)</c:formatCode>
                <c:ptCount val="12"/>
                <c:pt idx="0">
                  <c:v>6.4983416252072965</c:v>
                </c:pt>
                <c:pt idx="1">
                  <c:v>4.349367088607595</c:v>
                </c:pt>
                <c:pt idx="2">
                  <c:v>4.9507978723404253</c:v>
                </c:pt>
                <c:pt idx="3">
                  <c:v>8.7385800770500826</c:v>
                </c:pt>
                <c:pt idx="4">
                  <c:v>12.793326157158235</c:v>
                </c:pt>
                <c:pt idx="5">
                  <c:v>5.8770764119601333</c:v>
                </c:pt>
                <c:pt idx="6">
                  <c:v>5.6828478964401299</c:v>
                </c:pt>
                <c:pt idx="7">
                  <c:v>16.243781094527364</c:v>
                </c:pt>
                <c:pt idx="8">
                  <c:v>9.8526890101325026</c:v>
                </c:pt>
                <c:pt idx="9">
                  <c:v>5.1577726218097446</c:v>
                </c:pt>
                <c:pt idx="10">
                  <c:v>10.74619960343688</c:v>
                </c:pt>
                <c:pt idx="11">
                  <c:v>10.0412371134020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17D-EC48-84F1-B0F5DC1644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09197119"/>
        <c:axId val="1576830207"/>
        <c:axId val="24292464"/>
      </c:line3DChart>
      <c:catAx>
        <c:axId val="90919711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76830207"/>
        <c:crosses val="autoZero"/>
        <c:auto val="1"/>
        <c:lblAlgn val="ctr"/>
        <c:lblOffset val="100"/>
        <c:noMultiLvlLbl val="0"/>
      </c:catAx>
      <c:valAx>
        <c:axId val="15768302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_(* #,##0.00_);_(* \(#,##0.00\);_(* &quot;-&quot;??_);_(@_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09197119"/>
        <c:crosses val="autoZero"/>
        <c:crossBetween val="between"/>
      </c:valAx>
      <c:serAx>
        <c:axId val="2429246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76830207"/>
        <c:crosses val="autoZero"/>
      </c:ser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Plant Height predict. ML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plant height MLM model pred'!$K$1</c:f>
              <c:strCache>
                <c:ptCount val="1"/>
                <c:pt idx="0">
                  <c:v>predict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7.6578958880139977E-2"/>
                  <c:y val="0.1800776465441819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</c:trendlineLbl>
          </c:trendline>
          <c:xVal>
            <c:numRef>
              <c:f>'plant height MLM model pred'!$J$2:$J$158</c:f>
              <c:numCache>
                <c:formatCode>General</c:formatCode>
                <c:ptCount val="157"/>
                <c:pt idx="0">
                  <c:v>1</c:v>
                </c:pt>
                <c:pt idx="1">
                  <c:v>1</c:v>
                </c:pt>
                <c:pt idx="2">
                  <c:v>3</c:v>
                </c:pt>
                <c:pt idx="3">
                  <c:v>3</c:v>
                </c:pt>
                <c:pt idx="4">
                  <c:v>3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  <c:pt idx="12">
                  <c:v>4</c:v>
                </c:pt>
                <c:pt idx="13">
                  <c:v>4</c:v>
                </c:pt>
                <c:pt idx="14">
                  <c:v>4</c:v>
                </c:pt>
                <c:pt idx="15">
                  <c:v>4</c:v>
                </c:pt>
                <c:pt idx="16">
                  <c:v>4</c:v>
                </c:pt>
                <c:pt idx="17">
                  <c:v>4</c:v>
                </c:pt>
                <c:pt idx="18">
                  <c:v>4</c:v>
                </c:pt>
                <c:pt idx="19">
                  <c:v>4</c:v>
                </c:pt>
                <c:pt idx="20">
                  <c:v>4</c:v>
                </c:pt>
                <c:pt idx="21">
                  <c:v>4</c:v>
                </c:pt>
                <c:pt idx="22">
                  <c:v>4</c:v>
                </c:pt>
                <c:pt idx="23">
                  <c:v>5</c:v>
                </c:pt>
                <c:pt idx="24">
                  <c:v>5</c:v>
                </c:pt>
                <c:pt idx="25">
                  <c:v>5</c:v>
                </c:pt>
                <c:pt idx="26">
                  <c:v>5</c:v>
                </c:pt>
                <c:pt idx="27">
                  <c:v>5</c:v>
                </c:pt>
                <c:pt idx="28">
                  <c:v>5</c:v>
                </c:pt>
                <c:pt idx="29">
                  <c:v>5</c:v>
                </c:pt>
                <c:pt idx="30">
                  <c:v>5</c:v>
                </c:pt>
                <c:pt idx="31">
                  <c:v>5</c:v>
                </c:pt>
                <c:pt idx="32">
                  <c:v>5</c:v>
                </c:pt>
                <c:pt idx="33">
                  <c:v>5</c:v>
                </c:pt>
                <c:pt idx="34">
                  <c:v>5</c:v>
                </c:pt>
                <c:pt idx="35">
                  <c:v>5</c:v>
                </c:pt>
                <c:pt idx="36">
                  <c:v>5</c:v>
                </c:pt>
                <c:pt idx="37">
                  <c:v>5</c:v>
                </c:pt>
                <c:pt idx="38">
                  <c:v>5</c:v>
                </c:pt>
                <c:pt idx="39">
                  <c:v>5</c:v>
                </c:pt>
                <c:pt idx="40">
                  <c:v>5</c:v>
                </c:pt>
                <c:pt idx="41">
                  <c:v>5</c:v>
                </c:pt>
                <c:pt idx="42">
                  <c:v>5</c:v>
                </c:pt>
                <c:pt idx="43">
                  <c:v>5</c:v>
                </c:pt>
                <c:pt idx="44">
                  <c:v>5</c:v>
                </c:pt>
                <c:pt idx="45">
                  <c:v>5</c:v>
                </c:pt>
                <c:pt idx="46">
                  <c:v>5</c:v>
                </c:pt>
                <c:pt idx="47">
                  <c:v>5</c:v>
                </c:pt>
                <c:pt idx="48">
                  <c:v>5</c:v>
                </c:pt>
                <c:pt idx="49">
                  <c:v>5</c:v>
                </c:pt>
                <c:pt idx="50">
                  <c:v>5</c:v>
                </c:pt>
                <c:pt idx="51">
                  <c:v>5</c:v>
                </c:pt>
                <c:pt idx="52">
                  <c:v>5</c:v>
                </c:pt>
                <c:pt idx="53">
                  <c:v>5</c:v>
                </c:pt>
                <c:pt idx="54">
                  <c:v>5</c:v>
                </c:pt>
                <c:pt idx="55">
                  <c:v>6</c:v>
                </c:pt>
                <c:pt idx="56">
                  <c:v>6</c:v>
                </c:pt>
                <c:pt idx="57">
                  <c:v>6</c:v>
                </c:pt>
                <c:pt idx="58">
                  <c:v>6</c:v>
                </c:pt>
                <c:pt idx="59">
                  <c:v>6</c:v>
                </c:pt>
                <c:pt idx="60">
                  <c:v>6</c:v>
                </c:pt>
                <c:pt idx="61">
                  <c:v>6</c:v>
                </c:pt>
                <c:pt idx="62">
                  <c:v>6</c:v>
                </c:pt>
                <c:pt idx="63">
                  <c:v>6</c:v>
                </c:pt>
                <c:pt idx="64">
                  <c:v>6</c:v>
                </c:pt>
                <c:pt idx="65">
                  <c:v>6</c:v>
                </c:pt>
                <c:pt idx="66">
                  <c:v>6</c:v>
                </c:pt>
                <c:pt idx="67">
                  <c:v>6</c:v>
                </c:pt>
                <c:pt idx="68">
                  <c:v>6</c:v>
                </c:pt>
                <c:pt idx="69">
                  <c:v>6</c:v>
                </c:pt>
                <c:pt idx="70">
                  <c:v>6</c:v>
                </c:pt>
                <c:pt idx="71">
                  <c:v>6</c:v>
                </c:pt>
                <c:pt idx="72">
                  <c:v>6</c:v>
                </c:pt>
                <c:pt idx="73">
                  <c:v>6</c:v>
                </c:pt>
                <c:pt idx="74">
                  <c:v>6</c:v>
                </c:pt>
                <c:pt idx="75">
                  <c:v>6</c:v>
                </c:pt>
                <c:pt idx="76">
                  <c:v>6</c:v>
                </c:pt>
                <c:pt idx="77">
                  <c:v>6</c:v>
                </c:pt>
                <c:pt idx="78">
                  <c:v>6</c:v>
                </c:pt>
                <c:pt idx="79">
                  <c:v>6</c:v>
                </c:pt>
                <c:pt idx="80">
                  <c:v>6</c:v>
                </c:pt>
                <c:pt idx="81">
                  <c:v>6</c:v>
                </c:pt>
                <c:pt idx="82">
                  <c:v>6</c:v>
                </c:pt>
                <c:pt idx="83">
                  <c:v>6</c:v>
                </c:pt>
                <c:pt idx="84">
                  <c:v>6</c:v>
                </c:pt>
                <c:pt idx="85">
                  <c:v>6</c:v>
                </c:pt>
                <c:pt idx="86">
                  <c:v>6</c:v>
                </c:pt>
                <c:pt idx="87">
                  <c:v>6</c:v>
                </c:pt>
                <c:pt idx="88">
                  <c:v>6</c:v>
                </c:pt>
                <c:pt idx="89">
                  <c:v>6</c:v>
                </c:pt>
                <c:pt idx="90">
                  <c:v>6</c:v>
                </c:pt>
                <c:pt idx="91">
                  <c:v>6</c:v>
                </c:pt>
                <c:pt idx="92">
                  <c:v>6</c:v>
                </c:pt>
                <c:pt idx="93">
                  <c:v>6</c:v>
                </c:pt>
                <c:pt idx="94">
                  <c:v>6</c:v>
                </c:pt>
                <c:pt idx="95">
                  <c:v>6</c:v>
                </c:pt>
                <c:pt idx="96">
                  <c:v>7</c:v>
                </c:pt>
                <c:pt idx="97">
                  <c:v>7</c:v>
                </c:pt>
                <c:pt idx="98">
                  <c:v>7</c:v>
                </c:pt>
                <c:pt idx="99">
                  <c:v>7</c:v>
                </c:pt>
                <c:pt idx="100">
                  <c:v>7</c:v>
                </c:pt>
                <c:pt idx="101">
                  <c:v>7</c:v>
                </c:pt>
                <c:pt idx="102">
                  <c:v>7</c:v>
                </c:pt>
                <c:pt idx="103">
                  <c:v>7</c:v>
                </c:pt>
                <c:pt idx="104">
                  <c:v>7</c:v>
                </c:pt>
                <c:pt idx="105">
                  <c:v>7</c:v>
                </c:pt>
                <c:pt idx="106">
                  <c:v>7</c:v>
                </c:pt>
                <c:pt idx="107">
                  <c:v>7</c:v>
                </c:pt>
                <c:pt idx="108">
                  <c:v>7</c:v>
                </c:pt>
                <c:pt idx="109">
                  <c:v>7</c:v>
                </c:pt>
                <c:pt idx="110">
                  <c:v>7</c:v>
                </c:pt>
                <c:pt idx="111">
                  <c:v>7</c:v>
                </c:pt>
                <c:pt idx="112">
                  <c:v>7</c:v>
                </c:pt>
                <c:pt idx="113">
                  <c:v>7</c:v>
                </c:pt>
                <c:pt idx="114">
                  <c:v>7</c:v>
                </c:pt>
                <c:pt idx="115">
                  <c:v>7</c:v>
                </c:pt>
                <c:pt idx="116">
                  <c:v>7</c:v>
                </c:pt>
                <c:pt idx="117">
                  <c:v>7</c:v>
                </c:pt>
                <c:pt idx="118">
                  <c:v>7</c:v>
                </c:pt>
                <c:pt idx="119">
                  <c:v>7</c:v>
                </c:pt>
                <c:pt idx="120">
                  <c:v>7</c:v>
                </c:pt>
                <c:pt idx="121">
                  <c:v>7</c:v>
                </c:pt>
                <c:pt idx="122">
                  <c:v>7</c:v>
                </c:pt>
                <c:pt idx="123">
                  <c:v>7</c:v>
                </c:pt>
                <c:pt idx="124">
                  <c:v>7</c:v>
                </c:pt>
                <c:pt idx="125">
                  <c:v>7</c:v>
                </c:pt>
                <c:pt idx="126">
                  <c:v>7</c:v>
                </c:pt>
                <c:pt idx="127">
                  <c:v>7</c:v>
                </c:pt>
                <c:pt idx="128">
                  <c:v>7</c:v>
                </c:pt>
                <c:pt idx="129">
                  <c:v>7</c:v>
                </c:pt>
                <c:pt idx="130">
                  <c:v>7</c:v>
                </c:pt>
                <c:pt idx="131">
                  <c:v>7</c:v>
                </c:pt>
                <c:pt idx="132">
                  <c:v>7</c:v>
                </c:pt>
                <c:pt idx="133">
                  <c:v>7</c:v>
                </c:pt>
                <c:pt idx="134">
                  <c:v>7</c:v>
                </c:pt>
                <c:pt idx="135">
                  <c:v>7</c:v>
                </c:pt>
                <c:pt idx="136">
                  <c:v>7</c:v>
                </c:pt>
                <c:pt idx="137">
                  <c:v>7</c:v>
                </c:pt>
                <c:pt idx="138">
                  <c:v>7</c:v>
                </c:pt>
                <c:pt idx="139">
                  <c:v>7</c:v>
                </c:pt>
                <c:pt idx="140">
                  <c:v>7</c:v>
                </c:pt>
                <c:pt idx="141">
                  <c:v>8</c:v>
                </c:pt>
                <c:pt idx="142">
                  <c:v>8</c:v>
                </c:pt>
                <c:pt idx="143">
                  <c:v>8</c:v>
                </c:pt>
                <c:pt idx="144">
                  <c:v>8</c:v>
                </c:pt>
                <c:pt idx="145">
                  <c:v>8</c:v>
                </c:pt>
                <c:pt idx="146">
                  <c:v>8</c:v>
                </c:pt>
                <c:pt idx="147">
                  <c:v>8</c:v>
                </c:pt>
                <c:pt idx="148">
                  <c:v>8</c:v>
                </c:pt>
                <c:pt idx="149">
                  <c:v>8</c:v>
                </c:pt>
                <c:pt idx="150">
                  <c:v>8</c:v>
                </c:pt>
                <c:pt idx="151">
                  <c:v>8</c:v>
                </c:pt>
                <c:pt idx="152">
                  <c:v>8</c:v>
                </c:pt>
                <c:pt idx="153">
                  <c:v>9</c:v>
                </c:pt>
                <c:pt idx="154">
                  <c:v>9</c:v>
                </c:pt>
                <c:pt idx="155">
                  <c:v>9</c:v>
                </c:pt>
                <c:pt idx="156">
                  <c:v>9</c:v>
                </c:pt>
              </c:numCache>
            </c:numRef>
          </c:xVal>
          <c:yVal>
            <c:numRef>
              <c:f>'plant height MLM model pred'!$K$2:$K$158</c:f>
              <c:numCache>
                <c:formatCode>General</c:formatCode>
                <c:ptCount val="157"/>
                <c:pt idx="0">
                  <c:v>3.30560087805185</c:v>
                </c:pt>
                <c:pt idx="1">
                  <c:v>2.8974490465380698</c:v>
                </c:pt>
                <c:pt idx="2">
                  <c:v>4.1772690450644498</c:v>
                </c:pt>
                <c:pt idx="3">
                  <c:v>4.2227178743804501</c:v>
                </c:pt>
                <c:pt idx="4">
                  <c:v>4.5008488397053901</c:v>
                </c:pt>
                <c:pt idx="5">
                  <c:v>4.4044561433371898</c:v>
                </c:pt>
                <c:pt idx="6">
                  <c:v>3.6755430442632901</c:v>
                </c:pt>
                <c:pt idx="7">
                  <c:v>4.5005538159411804</c:v>
                </c:pt>
                <c:pt idx="8">
                  <c:v>5.3321818152350602</c:v>
                </c:pt>
                <c:pt idx="9">
                  <c:v>4.4572208892849003</c:v>
                </c:pt>
                <c:pt idx="10">
                  <c:v>4.5591504137454697</c:v>
                </c:pt>
                <c:pt idx="11">
                  <c:v>4.9294984789645202</c:v>
                </c:pt>
                <c:pt idx="12">
                  <c:v>4.95124969280789</c:v>
                </c:pt>
                <c:pt idx="13">
                  <c:v>4.4079457183755899</c:v>
                </c:pt>
                <c:pt idx="14">
                  <c:v>5.1228390599601701</c:v>
                </c:pt>
                <c:pt idx="15">
                  <c:v>4.9170149933885696</c:v>
                </c:pt>
                <c:pt idx="16">
                  <c:v>4.2086925860912698</c:v>
                </c:pt>
                <c:pt idx="17">
                  <c:v>5.0276832911904004</c:v>
                </c:pt>
                <c:pt idx="18">
                  <c:v>5.5681816815254201</c:v>
                </c:pt>
                <c:pt idx="19">
                  <c:v>5.0215073027932702</c:v>
                </c:pt>
                <c:pt idx="20">
                  <c:v>4.8952255398815501</c:v>
                </c:pt>
                <c:pt idx="21">
                  <c:v>4.9850924950861097</c:v>
                </c:pt>
                <c:pt idx="22">
                  <c:v>4.2796235644496496</c:v>
                </c:pt>
                <c:pt idx="23">
                  <c:v>4.7014960174638203</c:v>
                </c:pt>
                <c:pt idx="24">
                  <c:v>4.5984060899247403</c:v>
                </c:pt>
                <c:pt idx="25">
                  <c:v>5.7447276267831997</c:v>
                </c:pt>
                <c:pt idx="26">
                  <c:v>5.7508582919753701</c:v>
                </c:pt>
                <c:pt idx="27">
                  <c:v>5.6605281518158197</c:v>
                </c:pt>
                <c:pt idx="28">
                  <c:v>5.3759319707142597</c:v>
                </c:pt>
                <c:pt idx="29">
                  <c:v>4.8180734112802801</c:v>
                </c:pt>
                <c:pt idx="30">
                  <c:v>5.7239316975921097</c:v>
                </c:pt>
                <c:pt idx="31">
                  <c:v>5.5112969613156197</c:v>
                </c:pt>
                <c:pt idx="32">
                  <c:v>5.0072551496931803</c:v>
                </c:pt>
                <c:pt idx="33">
                  <c:v>5.1172596951034803</c:v>
                </c:pt>
                <c:pt idx="34">
                  <c:v>5.5058463397859096</c:v>
                </c:pt>
                <c:pt idx="35">
                  <c:v>6.2742791050476603</c:v>
                </c:pt>
                <c:pt idx="36">
                  <c:v>5.7164258746377801</c:v>
                </c:pt>
                <c:pt idx="37">
                  <c:v>5.2659911746315604</c:v>
                </c:pt>
                <c:pt idx="38">
                  <c:v>5.54261742935876</c:v>
                </c:pt>
                <c:pt idx="39">
                  <c:v>5.2680602887676198</c:v>
                </c:pt>
                <c:pt idx="40">
                  <c:v>5.8379088531877299</c:v>
                </c:pt>
                <c:pt idx="41">
                  <c:v>6.3826559068713404</c:v>
                </c:pt>
                <c:pt idx="42">
                  <c:v>5.1178836614159904</c:v>
                </c:pt>
                <c:pt idx="43">
                  <c:v>5.9725494072499599</c:v>
                </c:pt>
                <c:pt idx="44">
                  <c:v>5.15444545323271</c:v>
                </c:pt>
                <c:pt idx="45">
                  <c:v>5.8277021153908697</c:v>
                </c:pt>
                <c:pt idx="46">
                  <c:v>5.2473365414960398</c:v>
                </c:pt>
                <c:pt idx="47">
                  <c:v>5.1757181477675402</c:v>
                </c:pt>
                <c:pt idx="48">
                  <c:v>5.7864063695404697</c:v>
                </c:pt>
                <c:pt idx="49">
                  <c:v>5.2719369469879798</c:v>
                </c:pt>
                <c:pt idx="50">
                  <c:v>5.4166366901855296</c:v>
                </c:pt>
                <c:pt idx="51">
                  <c:v>4.7561999061313296</c:v>
                </c:pt>
                <c:pt idx="52">
                  <c:v>4.9610740171377703</c:v>
                </c:pt>
                <c:pt idx="53">
                  <c:v>5.5387799985950998</c:v>
                </c:pt>
                <c:pt idx="54">
                  <c:v>5.6960081858540699</c:v>
                </c:pt>
                <c:pt idx="55">
                  <c:v>5.4629332704928597</c:v>
                </c:pt>
                <c:pt idx="56">
                  <c:v>5.6943288123490197</c:v>
                </c:pt>
                <c:pt idx="57">
                  <c:v>5.5003511947408104</c:v>
                </c:pt>
                <c:pt idx="58">
                  <c:v>5.8717187939684203</c:v>
                </c:pt>
                <c:pt idx="59">
                  <c:v>5.5595016320389004</c:v>
                </c:pt>
                <c:pt idx="60">
                  <c:v>5.6033996484732702</c:v>
                </c:pt>
                <c:pt idx="61">
                  <c:v>6.3809614750346402</c:v>
                </c:pt>
                <c:pt idx="62">
                  <c:v>5.8919090164677401</c:v>
                </c:pt>
                <c:pt idx="63">
                  <c:v>6.3179772143725303</c:v>
                </c:pt>
                <c:pt idx="64">
                  <c:v>6.5472726295947501</c:v>
                </c:pt>
                <c:pt idx="65">
                  <c:v>6.2295331873493698</c:v>
                </c:pt>
                <c:pt idx="66">
                  <c:v>6.1927968632094998</c:v>
                </c:pt>
                <c:pt idx="67">
                  <c:v>6.4381087659697203</c:v>
                </c:pt>
                <c:pt idx="68">
                  <c:v>6.3121653046659603</c:v>
                </c:pt>
                <c:pt idx="69">
                  <c:v>6.3651031445826298</c:v>
                </c:pt>
                <c:pt idx="70">
                  <c:v>5.8158542849288297</c:v>
                </c:pt>
                <c:pt idx="71">
                  <c:v>6.2007309465868898</c:v>
                </c:pt>
                <c:pt idx="72">
                  <c:v>6.13943095521019</c:v>
                </c:pt>
                <c:pt idx="73">
                  <c:v>5.6779326364235096</c:v>
                </c:pt>
                <c:pt idx="74">
                  <c:v>6.3337064776589198</c:v>
                </c:pt>
                <c:pt idx="75">
                  <c:v>6.3657452835730801</c:v>
                </c:pt>
                <c:pt idx="76">
                  <c:v>5.5721987129883797</c:v>
                </c:pt>
                <c:pt idx="77">
                  <c:v>6.6982194902710299</c:v>
                </c:pt>
                <c:pt idx="78">
                  <c:v>4.8060006636973496</c:v>
                </c:pt>
                <c:pt idx="79">
                  <c:v>6.0424816771577001</c:v>
                </c:pt>
                <c:pt idx="80">
                  <c:v>5.8581595712300798</c:v>
                </c:pt>
                <c:pt idx="81">
                  <c:v>5.98340601169377</c:v>
                </c:pt>
                <c:pt idx="82">
                  <c:v>5.82639946754521</c:v>
                </c:pt>
                <c:pt idx="83">
                  <c:v>5.0326888238003296</c:v>
                </c:pt>
                <c:pt idx="84">
                  <c:v>6.08980119372315</c:v>
                </c:pt>
                <c:pt idx="85">
                  <c:v>6.4185871704060702</c:v>
                </c:pt>
                <c:pt idx="86">
                  <c:v>6.3812866651541702</c:v>
                </c:pt>
                <c:pt idx="87">
                  <c:v>6.2887661811794997</c:v>
                </c:pt>
                <c:pt idx="88">
                  <c:v>6.3647368813429601</c:v>
                </c:pt>
                <c:pt idx="89">
                  <c:v>6.0716678341591397</c:v>
                </c:pt>
                <c:pt idx="90">
                  <c:v>5.8379608892868102</c:v>
                </c:pt>
                <c:pt idx="91">
                  <c:v>6.3911433980980403</c:v>
                </c:pt>
                <c:pt idx="92">
                  <c:v>6.1582518009631197</c:v>
                </c:pt>
                <c:pt idx="93">
                  <c:v>6.5962935491165799</c:v>
                </c:pt>
                <c:pt idx="94">
                  <c:v>5.8397251704540398</c:v>
                </c:pt>
                <c:pt idx="95">
                  <c:v>6.2757636417346001</c:v>
                </c:pt>
                <c:pt idx="96">
                  <c:v>6.6152963032429604</c:v>
                </c:pt>
                <c:pt idx="97">
                  <c:v>6.7444968589916101</c:v>
                </c:pt>
                <c:pt idx="98">
                  <c:v>6.2666763761526996</c:v>
                </c:pt>
                <c:pt idx="99">
                  <c:v>6.2667578874567704</c:v>
                </c:pt>
                <c:pt idx="100">
                  <c:v>6.4519447949696502</c:v>
                </c:pt>
                <c:pt idx="101">
                  <c:v>6.72268942724022</c:v>
                </c:pt>
                <c:pt idx="102">
                  <c:v>6.5600345288171198</c:v>
                </c:pt>
                <c:pt idx="103">
                  <c:v>6.5699200834119598</c:v>
                </c:pt>
                <c:pt idx="104">
                  <c:v>6.8632598501193502</c:v>
                </c:pt>
                <c:pt idx="105">
                  <c:v>6.4871156430737003</c:v>
                </c:pt>
                <c:pt idx="106">
                  <c:v>6.71880155019368</c:v>
                </c:pt>
                <c:pt idx="107">
                  <c:v>6.5967691718322703</c:v>
                </c:pt>
                <c:pt idx="108">
                  <c:v>6.3935017587593297</c:v>
                </c:pt>
                <c:pt idx="109">
                  <c:v>7.1128627411034904</c:v>
                </c:pt>
                <c:pt idx="110">
                  <c:v>6.3425202571167603</c:v>
                </c:pt>
                <c:pt idx="111">
                  <c:v>6.51316024485764</c:v>
                </c:pt>
                <c:pt idx="112">
                  <c:v>5.9970123795640502</c:v>
                </c:pt>
                <c:pt idx="113">
                  <c:v>6.5489027254122503</c:v>
                </c:pt>
                <c:pt idx="114">
                  <c:v>6.6012021728606296</c:v>
                </c:pt>
                <c:pt idx="115">
                  <c:v>6.8805424741650896</c:v>
                </c:pt>
                <c:pt idx="116">
                  <c:v>6.3993469065267199</c:v>
                </c:pt>
                <c:pt idx="117">
                  <c:v>6.4876139571253004</c:v>
                </c:pt>
                <c:pt idx="118">
                  <c:v>6.8199521907624696</c:v>
                </c:pt>
                <c:pt idx="119">
                  <c:v>6.6807402536298097</c:v>
                </c:pt>
                <c:pt idx="120">
                  <c:v>6.2499059352770399</c:v>
                </c:pt>
                <c:pt idx="121">
                  <c:v>6.8362619657226098</c:v>
                </c:pt>
                <c:pt idx="122">
                  <c:v>5.8733365140475504</c:v>
                </c:pt>
                <c:pt idx="123">
                  <c:v>6.27347578594547</c:v>
                </c:pt>
                <c:pt idx="124">
                  <c:v>6.4538670559398499</c:v>
                </c:pt>
                <c:pt idx="125">
                  <c:v>6.8179315047697404</c:v>
                </c:pt>
                <c:pt idx="126">
                  <c:v>6.5590245000250897</c:v>
                </c:pt>
                <c:pt idx="127">
                  <c:v>6.4330545969962403</c:v>
                </c:pt>
                <c:pt idx="128">
                  <c:v>5.83747823695888</c:v>
                </c:pt>
                <c:pt idx="129">
                  <c:v>6.4738523151444403</c:v>
                </c:pt>
                <c:pt idx="130">
                  <c:v>6.8613581419120502</c:v>
                </c:pt>
                <c:pt idx="131">
                  <c:v>6.4657697269767702</c:v>
                </c:pt>
                <c:pt idx="132">
                  <c:v>6.0851477705363504</c:v>
                </c:pt>
                <c:pt idx="133">
                  <c:v>6.5314563389321103</c:v>
                </c:pt>
                <c:pt idx="134">
                  <c:v>6.1445108066647904</c:v>
                </c:pt>
                <c:pt idx="135">
                  <c:v>6.8224107197946298</c:v>
                </c:pt>
                <c:pt idx="136">
                  <c:v>6.31148501858664</c:v>
                </c:pt>
                <c:pt idx="137">
                  <c:v>5.9498216545600302</c:v>
                </c:pt>
                <c:pt idx="138">
                  <c:v>6.5475950666575002</c:v>
                </c:pt>
                <c:pt idx="139">
                  <c:v>6.58624398718971</c:v>
                </c:pt>
                <c:pt idx="140">
                  <c:v>6.8051335582556902</c:v>
                </c:pt>
                <c:pt idx="141">
                  <c:v>7.41638738624727</c:v>
                </c:pt>
                <c:pt idx="142">
                  <c:v>6.9855385550302698</c:v>
                </c:pt>
                <c:pt idx="143">
                  <c:v>7.3314787390557097</c:v>
                </c:pt>
                <c:pt idx="144">
                  <c:v>6.8157631370197604</c:v>
                </c:pt>
                <c:pt idx="145">
                  <c:v>7.19328066735204</c:v>
                </c:pt>
                <c:pt idx="146">
                  <c:v>6.2187677563371198</c:v>
                </c:pt>
                <c:pt idx="147">
                  <c:v>7.5755673830620101</c:v>
                </c:pt>
                <c:pt idx="148">
                  <c:v>7.4297966084159404</c:v>
                </c:pt>
                <c:pt idx="149">
                  <c:v>7.7061156555552799</c:v>
                </c:pt>
                <c:pt idx="150">
                  <c:v>7.3334073105004496</c:v>
                </c:pt>
                <c:pt idx="151">
                  <c:v>6.5953910180133999</c:v>
                </c:pt>
                <c:pt idx="152">
                  <c:v>7.03264402371512</c:v>
                </c:pt>
                <c:pt idx="153">
                  <c:v>7.6402612747529197</c:v>
                </c:pt>
                <c:pt idx="154">
                  <c:v>7.1469531030577</c:v>
                </c:pt>
                <c:pt idx="155">
                  <c:v>7.7620036295660402</c:v>
                </c:pt>
                <c:pt idx="156">
                  <c:v>7.74762799534961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495-A74F-A775-5BC74B7354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28630879"/>
        <c:axId val="1628632591"/>
      </c:scatterChart>
      <c:valAx>
        <c:axId val="162863087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28632591"/>
        <c:crosses val="autoZero"/>
        <c:crossBetween val="midCat"/>
      </c:valAx>
      <c:valAx>
        <c:axId val="162863259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2863087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Flw - Predic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GAPIT.MLM.TimeFflowering.PRED'!$E$1</c:f>
              <c:strCache>
                <c:ptCount val="1"/>
                <c:pt idx="0">
                  <c:v>Prediction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-8.7309930008748912E-2"/>
                  <c:y val="-1.8912219305920113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</c:trendlineLbl>
          </c:trendline>
          <c:xVal>
            <c:numRef>
              <c:f>'GAPIT.MLM.TimeFflowering.PRED'!$B$2:$B$284</c:f>
              <c:numCache>
                <c:formatCode>General</c:formatCode>
                <c:ptCount val="283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3</c:v>
                </c:pt>
                <c:pt idx="9">
                  <c:v>3</c:v>
                </c:pt>
                <c:pt idx="10">
                  <c:v>3</c:v>
                </c:pt>
                <c:pt idx="11">
                  <c:v>3</c:v>
                </c:pt>
                <c:pt idx="12">
                  <c:v>3</c:v>
                </c:pt>
                <c:pt idx="13">
                  <c:v>3</c:v>
                </c:pt>
                <c:pt idx="14">
                  <c:v>3</c:v>
                </c:pt>
                <c:pt idx="15">
                  <c:v>3</c:v>
                </c:pt>
                <c:pt idx="16">
                  <c:v>3</c:v>
                </c:pt>
                <c:pt idx="17">
                  <c:v>3</c:v>
                </c:pt>
                <c:pt idx="18">
                  <c:v>3</c:v>
                </c:pt>
                <c:pt idx="19">
                  <c:v>3</c:v>
                </c:pt>
                <c:pt idx="20">
                  <c:v>3</c:v>
                </c:pt>
                <c:pt idx="21">
                  <c:v>3</c:v>
                </c:pt>
                <c:pt idx="22">
                  <c:v>3</c:v>
                </c:pt>
                <c:pt idx="23">
                  <c:v>3</c:v>
                </c:pt>
                <c:pt idx="24">
                  <c:v>3</c:v>
                </c:pt>
                <c:pt idx="25">
                  <c:v>3</c:v>
                </c:pt>
                <c:pt idx="26">
                  <c:v>3</c:v>
                </c:pt>
                <c:pt idx="27">
                  <c:v>3</c:v>
                </c:pt>
                <c:pt idx="28">
                  <c:v>3</c:v>
                </c:pt>
                <c:pt idx="29">
                  <c:v>3</c:v>
                </c:pt>
                <c:pt idx="30">
                  <c:v>3</c:v>
                </c:pt>
                <c:pt idx="31">
                  <c:v>3</c:v>
                </c:pt>
                <c:pt idx="32">
                  <c:v>3</c:v>
                </c:pt>
                <c:pt idx="33">
                  <c:v>3</c:v>
                </c:pt>
                <c:pt idx="34">
                  <c:v>3</c:v>
                </c:pt>
                <c:pt idx="35">
                  <c:v>3</c:v>
                </c:pt>
                <c:pt idx="36">
                  <c:v>3</c:v>
                </c:pt>
                <c:pt idx="37">
                  <c:v>3</c:v>
                </c:pt>
                <c:pt idx="38">
                  <c:v>3</c:v>
                </c:pt>
                <c:pt idx="39">
                  <c:v>3</c:v>
                </c:pt>
                <c:pt idx="40">
                  <c:v>4</c:v>
                </c:pt>
                <c:pt idx="41">
                  <c:v>4</c:v>
                </c:pt>
                <c:pt idx="42">
                  <c:v>4</c:v>
                </c:pt>
                <c:pt idx="43">
                  <c:v>4</c:v>
                </c:pt>
                <c:pt idx="44">
                  <c:v>4</c:v>
                </c:pt>
                <c:pt idx="45">
                  <c:v>4</c:v>
                </c:pt>
                <c:pt idx="46">
                  <c:v>4</c:v>
                </c:pt>
                <c:pt idx="47">
                  <c:v>4</c:v>
                </c:pt>
                <c:pt idx="48">
                  <c:v>4</c:v>
                </c:pt>
                <c:pt idx="49">
                  <c:v>4</c:v>
                </c:pt>
                <c:pt idx="50">
                  <c:v>4</c:v>
                </c:pt>
                <c:pt idx="51">
                  <c:v>4</c:v>
                </c:pt>
                <c:pt idx="52">
                  <c:v>4</c:v>
                </c:pt>
                <c:pt idx="53">
                  <c:v>4</c:v>
                </c:pt>
                <c:pt idx="54">
                  <c:v>4</c:v>
                </c:pt>
                <c:pt idx="55">
                  <c:v>4</c:v>
                </c:pt>
                <c:pt idx="56">
                  <c:v>4</c:v>
                </c:pt>
                <c:pt idx="57">
                  <c:v>4</c:v>
                </c:pt>
                <c:pt idx="58">
                  <c:v>4</c:v>
                </c:pt>
                <c:pt idx="59">
                  <c:v>4</c:v>
                </c:pt>
                <c:pt idx="60">
                  <c:v>4</c:v>
                </c:pt>
                <c:pt idx="61">
                  <c:v>4</c:v>
                </c:pt>
                <c:pt idx="62">
                  <c:v>4</c:v>
                </c:pt>
                <c:pt idx="63">
                  <c:v>4</c:v>
                </c:pt>
                <c:pt idx="64">
                  <c:v>4</c:v>
                </c:pt>
                <c:pt idx="65">
                  <c:v>4</c:v>
                </c:pt>
                <c:pt idx="66">
                  <c:v>4</c:v>
                </c:pt>
                <c:pt idx="67">
                  <c:v>4</c:v>
                </c:pt>
                <c:pt idx="68">
                  <c:v>4</c:v>
                </c:pt>
                <c:pt idx="69">
                  <c:v>4</c:v>
                </c:pt>
                <c:pt idx="70">
                  <c:v>4</c:v>
                </c:pt>
                <c:pt idx="71">
                  <c:v>4</c:v>
                </c:pt>
                <c:pt idx="72">
                  <c:v>5</c:v>
                </c:pt>
                <c:pt idx="73">
                  <c:v>5</c:v>
                </c:pt>
                <c:pt idx="74">
                  <c:v>5</c:v>
                </c:pt>
                <c:pt idx="75">
                  <c:v>5</c:v>
                </c:pt>
                <c:pt idx="76">
                  <c:v>5</c:v>
                </c:pt>
                <c:pt idx="77">
                  <c:v>5</c:v>
                </c:pt>
                <c:pt idx="78">
                  <c:v>5</c:v>
                </c:pt>
                <c:pt idx="79">
                  <c:v>5</c:v>
                </c:pt>
                <c:pt idx="80">
                  <c:v>5</c:v>
                </c:pt>
                <c:pt idx="81">
                  <c:v>5</c:v>
                </c:pt>
                <c:pt idx="82">
                  <c:v>5</c:v>
                </c:pt>
                <c:pt idx="83">
                  <c:v>5</c:v>
                </c:pt>
                <c:pt idx="84">
                  <c:v>5</c:v>
                </c:pt>
                <c:pt idx="85">
                  <c:v>5</c:v>
                </c:pt>
                <c:pt idx="86">
                  <c:v>5</c:v>
                </c:pt>
                <c:pt idx="87">
                  <c:v>5</c:v>
                </c:pt>
                <c:pt idx="88">
                  <c:v>5</c:v>
                </c:pt>
                <c:pt idx="89">
                  <c:v>5</c:v>
                </c:pt>
                <c:pt idx="90">
                  <c:v>5</c:v>
                </c:pt>
                <c:pt idx="91">
                  <c:v>5</c:v>
                </c:pt>
                <c:pt idx="92">
                  <c:v>5</c:v>
                </c:pt>
                <c:pt idx="93">
                  <c:v>5</c:v>
                </c:pt>
                <c:pt idx="94">
                  <c:v>5</c:v>
                </c:pt>
                <c:pt idx="95">
                  <c:v>5</c:v>
                </c:pt>
                <c:pt idx="96">
                  <c:v>5</c:v>
                </c:pt>
                <c:pt idx="97">
                  <c:v>5</c:v>
                </c:pt>
                <c:pt idx="98">
                  <c:v>5</c:v>
                </c:pt>
                <c:pt idx="99">
                  <c:v>5</c:v>
                </c:pt>
                <c:pt idx="100">
                  <c:v>5</c:v>
                </c:pt>
                <c:pt idx="101">
                  <c:v>5</c:v>
                </c:pt>
                <c:pt idx="102">
                  <c:v>5</c:v>
                </c:pt>
                <c:pt idx="103">
                  <c:v>5</c:v>
                </c:pt>
                <c:pt idx="104">
                  <c:v>5</c:v>
                </c:pt>
                <c:pt idx="105">
                  <c:v>5</c:v>
                </c:pt>
                <c:pt idx="106">
                  <c:v>5</c:v>
                </c:pt>
                <c:pt idx="107">
                  <c:v>5</c:v>
                </c:pt>
                <c:pt idx="108">
                  <c:v>5</c:v>
                </c:pt>
                <c:pt idx="109">
                  <c:v>5</c:v>
                </c:pt>
                <c:pt idx="110">
                  <c:v>5</c:v>
                </c:pt>
                <c:pt idx="111">
                  <c:v>5</c:v>
                </c:pt>
                <c:pt idx="112">
                  <c:v>5</c:v>
                </c:pt>
                <c:pt idx="113">
                  <c:v>5</c:v>
                </c:pt>
                <c:pt idx="114">
                  <c:v>5</c:v>
                </c:pt>
                <c:pt idx="115">
                  <c:v>5</c:v>
                </c:pt>
                <c:pt idx="116">
                  <c:v>5</c:v>
                </c:pt>
                <c:pt idx="117">
                  <c:v>5</c:v>
                </c:pt>
                <c:pt idx="118">
                  <c:v>5</c:v>
                </c:pt>
                <c:pt idx="119">
                  <c:v>5</c:v>
                </c:pt>
                <c:pt idx="120">
                  <c:v>5</c:v>
                </c:pt>
                <c:pt idx="121">
                  <c:v>5</c:v>
                </c:pt>
                <c:pt idx="122">
                  <c:v>5</c:v>
                </c:pt>
                <c:pt idx="123">
                  <c:v>5</c:v>
                </c:pt>
                <c:pt idx="124">
                  <c:v>5</c:v>
                </c:pt>
                <c:pt idx="125">
                  <c:v>5</c:v>
                </c:pt>
                <c:pt idx="126">
                  <c:v>5</c:v>
                </c:pt>
                <c:pt idx="127">
                  <c:v>5</c:v>
                </c:pt>
                <c:pt idx="128">
                  <c:v>5</c:v>
                </c:pt>
                <c:pt idx="129">
                  <c:v>5</c:v>
                </c:pt>
                <c:pt idx="130">
                  <c:v>5</c:v>
                </c:pt>
                <c:pt idx="131">
                  <c:v>5</c:v>
                </c:pt>
                <c:pt idx="132">
                  <c:v>5</c:v>
                </c:pt>
                <c:pt idx="133">
                  <c:v>5</c:v>
                </c:pt>
                <c:pt idx="134">
                  <c:v>5</c:v>
                </c:pt>
                <c:pt idx="135">
                  <c:v>5</c:v>
                </c:pt>
                <c:pt idx="136">
                  <c:v>5</c:v>
                </c:pt>
                <c:pt idx="137">
                  <c:v>5</c:v>
                </c:pt>
                <c:pt idx="138">
                  <c:v>5</c:v>
                </c:pt>
                <c:pt idx="139">
                  <c:v>5</c:v>
                </c:pt>
                <c:pt idx="140">
                  <c:v>5</c:v>
                </c:pt>
                <c:pt idx="141">
                  <c:v>5</c:v>
                </c:pt>
                <c:pt idx="142">
                  <c:v>5</c:v>
                </c:pt>
                <c:pt idx="143">
                  <c:v>5</c:v>
                </c:pt>
                <c:pt idx="144">
                  <c:v>5</c:v>
                </c:pt>
                <c:pt idx="145">
                  <c:v>5</c:v>
                </c:pt>
                <c:pt idx="146">
                  <c:v>5</c:v>
                </c:pt>
                <c:pt idx="147">
                  <c:v>5</c:v>
                </c:pt>
                <c:pt idx="148">
                  <c:v>5</c:v>
                </c:pt>
                <c:pt idx="149">
                  <c:v>5</c:v>
                </c:pt>
                <c:pt idx="150">
                  <c:v>5</c:v>
                </c:pt>
                <c:pt idx="151">
                  <c:v>5</c:v>
                </c:pt>
                <c:pt idx="152">
                  <c:v>5</c:v>
                </c:pt>
                <c:pt idx="153">
                  <c:v>5</c:v>
                </c:pt>
                <c:pt idx="154">
                  <c:v>5</c:v>
                </c:pt>
                <c:pt idx="155">
                  <c:v>5</c:v>
                </c:pt>
                <c:pt idx="156">
                  <c:v>5</c:v>
                </c:pt>
                <c:pt idx="157">
                  <c:v>5</c:v>
                </c:pt>
                <c:pt idx="158">
                  <c:v>5</c:v>
                </c:pt>
                <c:pt idx="159">
                  <c:v>5</c:v>
                </c:pt>
                <c:pt idx="160">
                  <c:v>5</c:v>
                </c:pt>
                <c:pt idx="161">
                  <c:v>5</c:v>
                </c:pt>
                <c:pt idx="162">
                  <c:v>5</c:v>
                </c:pt>
                <c:pt idx="163">
                  <c:v>5</c:v>
                </c:pt>
                <c:pt idx="164">
                  <c:v>5</c:v>
                </c:pt>
                <c:pt idx="165">
                  <c:v>5</c:v>
                </c:pt>
                <c:pt idx="166">
                  <c:v>5</c:v>
                </c:pt>
                <c:pt idx="167">
                  <c:v>5</c:v>
                </c:pt>
                <c:pt idx="168">
                  <c:v>5</c:v>
                </c:pt>
                <c:pt idx="169">
                  <c:v>5</c:v>
                </c:pt>
                <c:pt idx="170">
                  <c:v>5</c:v>
                </c:pt>
                <c:pt idx="171">
                  <c:v>5</c:v>
                </c:pt>
                <c:pt idx="172">
                  <c:v>5</c:v>
                </c:pt>
                <c:pt idx="173">
                  <c:v>5</c:v>
                </c:pt>
                <c:pt idx="174">
                  <c:v>5</c:v>
                </c:pt>
                <c:pt idx="175">
                  <c:v>5</c:v>
                </c:pt>
                <c:pt idx="176">
                  <c:v>6</c:v>
                </c:pt>
                <c:pt idx="177">
                  <c:v>6</c:v>
                </c:pt>
                <c:pt idx="178">
                  <c:v>6</c:v>
                </c:pt>
                <c:pt idx="179">
                  <c:v>6</c:v>
                </c:pt>
                <c:pt idx="180">
                  <c:v>6</c:v>
                </c:pt>
                <c:pt idx="181">
                  <c:v>6</c:v>
                </c:pt>
                <c:pt idx="182">
                  <c:v>6</c:v>
                </c:pt>
                <c:pt idx="183">
                  <c:v>6</c:v>
                </c:pt>
                <c:pt idx="184">
                  <c:v>6</c:v>
                </c:pt>
                <c:pt idx="185">
                  <c:v>6</c:v>
                </c:pt>
                <c:pt idx="186">
                  <c:v>6</c:v>
                </c:pt>
                <c:pt idx="187">
                  <c:v>6</c:v>
                </c:pt>
                <c:pt idx="188">
                  <c:v>6</c:v>
                </c:pt>
                <c:pt idx="189">
                  <c:v>6</c:v>
                </c:pt>
                <c:pt idx="190">
                  <c:v>6</c:v>
                </c:pt>
                <c:pt idx="191">
                  <c:v>6</c:v>
                </c:pt>
                <c:pt idx="192">
                  <c:v>6</c:v>
                </c:pt>
                <c:pt idx="193">
                  <c:v>6</c:v>
                </c:pt>
                <c:pt idx="194">
                  <c:v>6</c:v>
                </c:pt>
                <c:pt idx="195">
                  <c:v>6</c:v>
                </c:pt>
                <c:pt idx="196">
                  <c:v>6</c:v>
                </c:pt>
                <c:pt idx="197">
                  <c:v>6</c:v>
                </c:pt>
                <c:pt idx="198">
                  <c:v>6</c:v>
                </c:pt>
                <c:pt idx="199">
                  <c:v>6</c:v>
                </c:pt>
                <c:pt idx="200">
                  <c:v>6</c:v>
                </c:pt>
                <c:pt idx="201">
                  <c:v>7</c:v>
                </c:pt>
                <c:pt idx="202">
                  <c:v>7</c:v>
                </c:pt>
                <c:pt idx="203">
                  <c:v>7</c:v>
                </c:pt>
                <c:pt idx="204">
                  <c:v>7</c:v>
                </c:pt>
                <c:pt idx="205">
                  <c:v>7</c:v>
                </c:pt>
                <c:pt idx="206">
                  <c:v>7</c:v>
                </c:pt>
                <c:pt idx="207">
                  <c:v>7</c:v>
                </c:pt>
                <c:pt idx="208">
                  <c:v>7</c:v>
                </c:pt>
                <c:pt idx="209">
                  <c:v>7</c:v>
                </c:pt>
                <c:pt idx="210">
                  <c:v>7</c:v>
                </c:pt>
                <c:pt idx="211">
                  <c:v>7</c:v>
                </c:pt>
                <c:pt idx="212">
                  <c:v>7</c:v>
                </c:pt>
                <c:pt idx="213">
                  <c:v>7</c:v>
                </c:pt>
                <c:pt idx="214">
                  <c:v>7</c:v>
                </c:pt>
                <c:pt idx="215">
                  <c:v>7</c:v>
                </c:pt>
                <c:pt idx="216">
                  <c:v>7</c:v>
                </c:pt>
                <c:pt idx="217">
                  <c:v>7</c:v>
                </c:pt>
                <c:pt idx="218">
                  <c:v>7</c:v>
                </c:pt>
                <c:pt idx="219">
                  <c:v>7</c:v>
                </c:pt>
                <c:pt idx="220">
                  <c:v>7</c:v>
                </c:pt>
                <c:pt idx="221">
                  <c:v>7</c:v>
                </c:pt>
                <c:pt idx="222">
                  <c:v>7</c:v>
                </c:pt>
                <c:pt idx="223">
                  <c:v>7</c:v>
                </c:pt>
                <c:pt idx="224">
                  <c:v>8</c:v>
                </c:pt>
                <c:pt idx="225">
                  <c:v>8</c:v>
                </c:pt>
                <c:pt idx="226">
                  <c:v>8</c:v>
                </c:pt>
                <c:pt idx="227">
                  <c:v>8</c:v>
                </c:pt>
                <c:pt idx="228">
                  <c:v>8</c:v>
                </c:pt>
                <c:pt idx="229">
                  <c:v>8</c:v>
                </c:pt>
                <c:pt idx="230">
                  <c:v>8</c:v>
                </c:pt>
                <c:pt idx="231">
                  <c:v>8</c:v>
                </c:pt>
                <c:pt idx="232">
                  <c:v>9</c:v>
                </c:pt>
              </c:numCache>
            </c:numRef>
          </c:xVal>
          <c:yVal>
            <c:numRef>
              <c:f>'GAPIT.MLM.TimeFflowering.PRED'!$E$2:$E$284</c:f>
              <c:numCache>
                <c:formatCode>General</c:formatCode>
                <c:ptCount val="283"/>
                <c:pt idx="0">
                  <c:v>2.0027428587689098</c:v>
                </c:pt>
                <c:pt idx="1">
                  <c:v>3.7231906187116599</c:v>
                </c:pt>
                <c:pt idx="2">
                  <c:v>2.3225678959225</c:v>
                </c:pt>
                <c:pt idx="3">
                  <c:v>2.8046604899708298</c:v>
                </c:pt>
                <c:pt idx="4">
                  <c:v>2.9224562801774598</c:v>
                </c:pt>
                <c:pt idx="5">
                  <c:v>2.8738582873871299</c:v>
                </c:pt>
                <c:pt idx="6">
                  <c:v>2.1609289115646102</c:v>
                </c:pt>
                <c:pt idx="7">
                  <c:v>2.91965427549346</c:v>
                </c:pt>
                <c:pt idx="8">
                  <c:v>2.6753058395664202</c:v>
                </c:pt>
                <c:pt idx="9">
                  <c:v>4.57917841450395</c:v>
                </c:pt>
                <c:pt idx="10">
                  <c:v>3.5516861370605901</c:v>
                </c:pt>
                <c:pt idx="11">
                  <c:v>4.2138476464069496</c:v>
                </c:pt>
                <c:pt idx="12">
                  <c:v>3.8984227389359298</c:v>
                </c:pt>
                <c:pt idx="13">
                  <c:v>3.0917386975933101</c:v>
                </c:pt>
                <c:pt idx="14">
                  <c:v>3.5365723466174201</c:v>
                </c:pt>
                <c:pt idx="15">
                  <c:v>4.1678076744974604</c:v>
                </c:pt>
                <c:pt idx="16">
                  <c:v>3.52589290189231</c:v>
                </c:pt>
                <c:pt idx="17">
                  <c:v>3.1908455545164598</c:v>
                </c:pt>
                <c:pt idx="18">
                  <c:v>3.0375735131347401</c:v>
                </c:pt>
                <c:pt idx="19">
                  <c:v>3.9858729883195698</c:v>
                </c:pt>
                <c:pt idx="20">
                  <c:v>3.0598120419095101</c:v>
                </c:pt>
                <c:pt idx="21">
                  <c:v>3.53467043837012</c:v>
                </c:pt>
                <c:pt idx="22">
                  <c:v>2.9084093658235202</c:v>
                </c:pt>
                <c:pt idx="23">
                  <c:v>4.3006744638924603</c:v>
                </c:pt>
                <c:pt idx="24">
                  <c:v>3.54267689614873</c:v>
                </c:pt>
                <c:pt idx="25">
                  <c:v>3.41926229559291</c:v>
                </c:pt>
                <c:pt idx="26">
                  <c:v>3.23785351828292</c:v>
                </c:pt>
                <c:pt idx="27">
                  <c:v>3.2700086437188398</c:v>
                </c:pt>
                <c:pt idx="28">
                  <c:v>3.5733185281084299</c:v>
                </c:pt>
                <c:pt idx="29">
                  <c:v>4.3397765129207402</c:v>
                </c:pt>
                <c:pt idx="30">
                  <c:v>3.0616125852435898</c:v>
                </c:pt>
                <c:pt idx="31">
                  <c:v>3.28710089753254</c:v>
                </c:pt>
                <c:pt idx="32">
                  <c:v>3.46807621001421</c:v>
                </c:pt>
                <c:pt idx="33">
                  <c:v>4.55091397579573</c:v>
                </c:pt>
                <c:pt idx="34">
                  <c:v>3.3971288918924198</c:v>
                </c:pt>
                <c:pt idx="35">
                  <c:v>3.20295834080994</c:v>
                </c:pt>
                <c:pt idx="36">
                  <c:v>3.6008081817018001</c:v>
                </c:pt>
                <c:pt idx="37">
                  <c:v>3.2491596358733399</c:v>
                </c:pt>
                <c:pt idx="38">
                  <c:v>3.1319327077337502</c:v>
                </c:pt>
                <c:pt idx="39">
                  <c:v>3.26116529738563</c:v>
                </c:pt>
                <c:pt idx="40">
                  <c:v>4.3589318209148002</c:v>
                </c:pt>
                <c:pt idx="41">
                  <c:v>4.5380095903697004</c:v>
                </c:pt>
                <c:pt idx="42">
                  <c:v>4.0564094114728304</c:v>
                </c:pt>
                <c:pt idx="43">
                  <c:v>4.8957920359183902</c:v>
                </c:pt>
                <c:pt idx="44">
                  <c:v>4.7954322795002797</c:v>
                </c:pt>
                <c:pt idx="45">
                  <c:v>3.5304464340408699</c:v>
                </c:pt>
                <c:pt idx="46">
                  <c:v>3.5918567862134401</c:v>
                </c:pt>
                <c:pt idx="47">
                  <c:v>3.8946718259903701</c:v>
                </c:pt>
                <c:pt idx="48">
                  <c:v>4.5080052775489898</c:v>
                </c:pt>
                <c:pt idx="49">
                  <c:v>4.1486622196617899</c:v>
                </c:pt>
                <c:pt idx="50">
                  <c:v>4.6805898246318502</c:v>
                </c:pt>
                <c:pt idx="51">
                  <c:v>3.7779693427385102</c:v>
                </c:pt>
                <c:pt idx="52">
                  <c:v>4.2007045823414098</c:v>
                </c:pt>
                <c:pt idx="53">
                  <c:v>4.0724295202208296</c:v>
                </c:pt>
                <c:pt idx="54">
                  <c:v>4.5821428864124298</c:v>
                </c:pt>
                <c:pt idx="55">
                  <c:v>5.1089959642729603</c:v>
                </c:pt>
                <c:pt idx="56">
                  <c:v>3.9770418848136799</c:v>
                </c:pt>
                <c:pt idx="57">
                  <c:v>4.0562283237641301</c:v>
                </c:pt>
                <c:pt idx="58">
                  <c:v>3.7797381055543</c:v>
                </c:pt>
                <c:pt idx="59">
                  <c:v>3.8540767658489399</c:v>
                </c:pt>
                <c:pt idx="60">
                  <c:v>4.9029756190794798</c:v>
                </c:pt>
                <c:pt idx="61">
                  <c:v>3.6360637814974299</c:v>
                </c:pt>
                <c:pt idx="62">
                  <c:v>3.4974251606301299</c:v>
                </c:pt>
                <c:pt idx="63">
                  <c:v>5.1471242997948199</c:v>
                </c:pt>
                <c:pt idx="64">
                  <c:v>3.7271225507749901</c:v>
                </c:pt>
                <c:pt idx="65">
                  <c:v>5.7867975072457201</c:v>
                </c:pt>
                <c:pt idx="66">
                  <c:v>3.5802649197000198</c:v>
                </c:pt>
                <c:pt idx="67">
                  <c:v>3.3363968767811101</c:v>
                </c:pt>
                <c:pt idx="68">
                  <c:v>3.6335556749001299</c:v>
                </c:pt>
                <c:pt idx="69">
                  <c:v>5.2999810918777399</c:v>
                </c:pt>
                <c:pt idx="70">
                  <c:v>4.9163383973504597</c:v>
                </c:pt>
                <c:pt idx="71">
                  <c:v>4.5388572089040897</c:v>
                </c:pt>
                <c:pt idx="72">
                  <c:v>5.0293577784863297</c:v>
                </c:pt>
                <c:pt idx="73">
                  <c:v>4.8337891623121303</c:v>
                </c:pt>
                <c:pt idx="74">
                  <c:v>4.6016433293056904</c:v>
                </c:pt>
                <c:pt idx="75">
                  <c:v>4.10203456190228</c:v>
                </c:pt>
                <c:pt idx="76">
                  <c:v>4.5501740291684802</c:v>
                </c:pt>
                <c:pt idx="77">
                  <c:v>4.9079916760728501</c:v>
                </c:pt>
                <c:pt idx="78">
                  <c:v>4.6797807713569899</c:v>
                </c:pt>
                <c:pt idx="79">
                  <c:v>4.56834612303419</c:v>
                </c:pt>
                <c:pt idx="80">
                  <c:v>5.5434573119143797</c:v>
                </c:pt>
                <c:pt idx="81">
                  <c:v>5.1495350647473197</c:v>
                </c:pt>
                <c:pt idx="82">
                  <c:v>5.3201025500751298</c:v>
                </c:pt>
                <c:pt idx="83">
                  <c:v>5.1606837834089401</c:v>
                </c:pt>
                <c:pt idx="84">
                  <c:v>4.7102567051325304</c:v>
                </c:pt>
                <c:pt idx="85">
                  <c:v>4.7418983407821296</c:v>
                </c:pt>
                <c:pt idx="86">
                  <c:v>4.8539160753994404</c:v>
                </c:pt>
                <c:pt idx="87">
                  <c:v>4.7773443030504703</c:v>
                </c:pt>
                <c:pt idx="88">
                  <c:v>4.87741566477722</c:v>
                </c:pt>
                <c:pt idx="89">
                  <c:v>4.9221142287785602</c:v>
                </c:pt>
                <c:pt idx="90">
                  <c:v>5.1968921501798304</c:v>
                </c:pt>
                <c:pt idx="91">
                  <c:v>4.9903869921198298</c:v>
                </c:pt>
                <c:pt idx="92">
                  <c:v>4.8426193461432598</c:v>
                </c:pt>
                <c:pt idx="93">
                  <c:v>4.9788452340172897</c:v>
                </c:pt>
                <c:pt idx="94">
                  <c:v>5.2471481868540204</c:v>
                </c:pt>
                <c:pt idx="95">
                  <c:v>4.8385561170600599</c:v>
                </c:pt>
                <c:pt idx="96">
                  <c:v>4.9075125701651299</c:v>
                </c:pt>
                <c:pt idx="97">
                  <c:v>5.3941407018256404</c:v>
                </c:pt>
                <c:pt idx="98">
                  <c:v>4.88298753778085</c:v>
                </c:pt>
                <c:pt idx="99">
                  <c:v>5.6887883096326597</c:v>
                </c:pt>
                <c:pt idx="100">
                  <c:v>5.09996196586376</c:v>
                </c:pt>
                <c:pt idx="101">
                  <c:v>5.1058425110954602</c:v>
                </c:pt>
                <c:pt idx="102">
                  <c:v>4.6913970252205797</c:v>
                </c:pt>
                <c:pt idx="103">
                  <c:v>5.4809161877323804</c:v>
                </c:pt>
                <c:pt idx="104">
                  <c:v>4.1888191993767796</c:v>
                </c:pt>
                <c:pt idx="105">
                  <c:v>5.2567846667474099</c:v>
                </c:pt>
                <c:pt idx="106">
                  <c:v>5.3568378419680798</c:v>
                </c:pt>
                <c:pt idx="107">
                  <c:v>5.3593387340073297</c:v>
                </c:pt>
                <c:pt idx="108">
                  <c:v>4.6192084686602897</c:v>
                </c:pt>
                <c:pt idx="109">
                  <c:v>5.2151589434824297</c:v>
                </c:pt>
                <c:pt idx="110">
                  <c:v>4.52636079288592</c:v>
                </c:pt>
                <c:pt idx="111">
                  <c:v>5.4142094872781001</c:v>
                </c:pt>
                <c:pt idx="112">
                  <c:v>5.3023903669489796</c:v>
                </c:pt>
                <c:pt idx="113">
                  <c:v>4.3244888393311296</c:v>
                </c:pt>
                <c:pt idx="114">
                  <c:v>5.2698151960697004</c:v>
                </c:pt>
                <c:pt idx="115">
                  <c:v>5.46626019298205</c:v>
                </c:pt>
                <c:pt idx="116">
                  <c:v>5.1117916199484004</c:v>
                </c:pt>
                <c:pt idx="117">
                  <c:v>4.8243357714514303</c:v>
                </c:pt>
                <c:pt idx="118">
                  <c:v>5.0611310865905201</c:v>
                </c:pt>
                <c:pt idx="119">
                  <c:v>5.6366883189952404</c:v>
                </c:pt>
                <c:pt idx="120">
                  <c:v>5.7919941700161699</c:v>
                </c:pt>
                <c:pt idx="121">
                  <c:v>4.9111383066653103</c:v>
                </c:pt>
                <c:pt idx="122">
                  <c:v>4.9110449084965202</c:v>
                </c:pt>
                <c:pt idx="123">
                  <c:v>5.1841590172673797</c:v>
                </c:pt>
                <c:pt idx="124">
                  <c:v>5.2488796233330302</c:v>
                </c:pt>
                <c:pt idx="125">
                  <c:v>3.7903411922408101</c:v>
                </c:pt>
                <c:pt idx="126">
                  <c:v>6.0373342992296299</c:v>
                </c:pt>
                <c:pt idx="127">
                  <c:v>5.0256474344799997</c:v>
                </c:pt>
                <c:pt idx="128">
                  <c:v>5.359346989993</c:v>
                </c:pt>
                <c:pt idx="129">
                  <c:v>5.6187625222865103</c:v>
                </c:pt>
                <c:pt idx="130">
                  <c:v>5.2981718464850402</c:v>
                </c:pt>
                <c:pt idx="131">
                  <c:v>5.3071785721609102</c:v>
                </c:pt>
                <c:pt idx="132">
                  <c:v>5.2439065492354002</c:v>
                </c:pt>
                <c:pt idx="133">
                  <c:v>5.7334758601816302</c:v>
                </c:pt>
                <c:pt idx="134">
                  <c:v>4.5430487336710099</c:v>
                </c:pt>
                <c:pt idx="135">
                  <c:v>5.33646047049975</c:v>
                </c:pt>
                <c:pt idx="136">
                  <c:v>5.2632012774781796</c:v>
                </c:pt>
                <c:pt idx="137">
                  <c:v>5.0528060466188398</c:v>
                </c:pt>
                <c:pt idx="138">
                  <c:v>5.2888214116755004</c:v>
                </c:pt>
                <c:pt idx="139">
                  <c:v>5.1105513960515401</c:v>
                </c:pt>
                <c:pt idx="140">
                  <c:v>4.7262288705516102</c:v>
                </c:pt>
                <c:pt idx="141">
                  <c:v>5.0283210553066704</c:v>
                </c:pt>
                <c:pt idx="142">
                  <c:v>5.0796926781002396</c:v>
                </c:pt>
                <c:pt idx="143">
                  <c:v>4.7339186158307101</c:v>
                </c:pt>
                <c:pt idx="144">
                  <c:v>5.5045900364806899</c:v>
                </c:pt>
                <c:pt idx="145">
                  <c:v>5.2554909395735701</c:v>
                </c:pt>
                <c:pt idx="146">
                  <c:v>5.4461041710160796</c:v>
                </c:pt>
                <c:pt idx="147">
                  <c:v>5.0106921368443</c:v>
                </c:pt>
                <c:pt idx="148">
                  <c:v>4.5058769419258198</c:v>
                </c:pt>
                <c:pt idx="149">
                  <c:v>5.5450204000184398</c:v>
                </c:pt>
                <c:pt idx="150">
                  <c:v>5.4538148202366799</c:v>
                </c:pt>
                <c:pt idx="151">
                  <c:v>5.1747492878540999</c:v>
                </c:pt>
                <c:pt idx="152">
                  <c:v>5.1020945261287398</c:v>
                </c:pt>
                <c:pt idx="153">
                  <c:v>5.3692019436330796</c:v>
                </c:pt>
                <c:pt idx="154">
                  <c:v>5.4142950712211801</c:v>
                </c:pt>
                <c:pt idx="155">
                  <c:v>5.2429198272149504</c:v>
                </c:pt>
                <c:pt idx="156">
                  <c:v>4.7884994994868597</c:v>
                </c:pt>
                <c:pt idx="157">
                  <c:v>5.4541803148761696</c:v>
                </c:pt>
                <c:pt idx="158">
                  <c:v>5.49791688772725</c:v>
                </c:pt>
                <c:pt idx="159">
                  <c:v>5.0133466601499599</c:v>
                </c:pt>
                <c:pt idx="160">
                  <c:v>5.29247182801228</c:v>
                </c:pt>
                <c:pt idx="161">
                  <c:v>5.3638248379812001</c:v>
                </c:pt>
                <c:pt idx="162">
                  <c:v>5.1186621079180599</c:v>
                </c:pt>
                <c:pt idx="163">
                  <c:v>3.9306734351190502</c:v>
                </c:pt>
                <c:pt idx="164">
                  <c:v>5.9949724945031599</c:v>
                </c:pt>
                <c:pt idx="165">
                  <c:v>4.1668067125677597</c:v>
                </c:pt>
                <c:pt idx="166">
                  <c:v>4.9626713771391904</c:v>
                </c:pt>
                <c:pt idx="167">
                  <c:v>5.1134762598782499</c:v>
                </c:pt>
                <c:pt idx="168">
                  <c:v>5.1872861750484498</c:v>
                </c:pt>
                <c:pt idx="169">
                  <c:v>4.97442389419792</c:v>
                </c:pt>
                <c:pt idx="170">
                  <c:v>5.1088101090971199</c:v>
                </c:pt>
                <c:pt idx="171">
                  <c:v>5.3070709241359797</c:v>
                </c:pt>
                <c:pt idx="172">
                  <c:v>5.17242958993576</c:v>
                </c:pt>
                <c:pt idx="173">
                  <c:v>5.3067224907051598</c:v>
                </c:pt>
                <c:pt idx="174">
                  <c:v>5.45517450931069</c:v>
                </c:pt>
                <c:pt idx="175">
                  <c:v>4.7929366582998201</c:v>
                </c:pt>
                <c:pt idx="176">
                  <c:v>4.9995597972887103</c:v>
                </c:pt>
                <c:pt idx="177">
                  <c:v>5.7316816674061801</c:v>
                </c:pt>
                <c:pt idx="178">
                  <c:v>5.5392666369838599</c:v>
                </c:pt>
                <c:pt idx="179">
                  <c:v>5.2639752261621897</c:v>
                </c:pt>
                <c:pt idx="180">
                  <c:v>5.6933831481832797</c:v>
                </c:pt>
                <c:pt idx="181">
                  <c:v>5.2003621652892704</c:v>
                </c:pt>
                <c:pt idx="182">
                  <c:v>5.7275951461138197</c:v>
                </c:pt>
                <c:pt idx="183">
                  <c:v>5.8731237074495599</c:v>
                </c:pt>
                <c:pt idx="184">
                  <c:v>5.9985526667834197</c:v>
                </c:pt>
                <c:pt idx="185">
                  <c:v>6.0047894221068097</c:v>
                </c:pt>
                <c:pt idx="186">
                  <c:v>5.7625137606586696</c:v>
                </c:pt>
                <c:pt idx="187">
                  <c:v>5.5375795580034204</c:v>
                </c:pt>
                <c:pt idx="188">
                  <c:v>5.26279388637069</c:v>
                </c:pt>
                <c:pt idx="189">
                  <c:v>5.2403232386571004</c:v>
                </c:pt>
                <c:pt idx="190">
                  <c:v>5.9961511185653196</c:v>
                </c:pt>
                <c:pt idx="191">
                  <c:v>5.4563818361396201</c:v>
                </c:pt>
                <c:pt idx="192">
                  <c:v>5.9732127359737204</c:v>
                </c:pt>
                <c:pt idx="193">
                  <c:v>5.43705729333597</c:v>
                </c:pt>
                <c:pt idx="194">
                  <c:v>6.0018309420926599</c:v>
                </c:pt>
                <c:pt idx="195">
                  <c:v>5.7640683875114096</c:v>
                </c:pt>
                <c:pt idx="196">
                  <c:v>5.4660503952894199</c:v>
                </c:pt>
                <c:pt idx="197">
                  <c:v>5.4827042651220799</c:v>
                </c:pt>
                <c:pt idx="198">
                  <c:v>6.0936742632468599</c:v>
                </c:pt>
                <c:pt idx="199">
                  <c:v>5.6657232244688398</c:v>
                </c:pt>
                <c:pt idx="200">
                  <c:v>5.6456635891536102</c:v>
                </c:pt>
                <c:pt idx="201">
                  <c:v>5.5500042854869598</c:v>
                </c:pt>
                <c:pt idx="202">
                  <c:v>5.7111353696399396</c:v>
                </c:pt>
                <c:pt idx="203">
                  <c:v>6.0387129017554999</c:v>
                </c:pt>
                <c:pt idx="204">
                  <c:v>5.9741051085499501</c:v>
                </c:pt>
                <c:pt idx="205">
                  <c:v>6.2904460143544103</c:v>
                </c:pt>
                <c:pt idx="206">
                  <c:v>6.3028428300827599</c:v>
                </c:pt>
                <c:pt idx="207">
                  <c:v>5.6059601136389503</c:v>
                </c:pt>
                <c:pt idx="208">
                  <c:v>6.2820428420677104</c:v>
                </c:pt>
                <c:pt idx="209">
                  <c:v>6.7274077676333901</c:v>
                </c:pt>
                <c:pt idx="210">
                  <c:v>6.13075855520316</c:v>
                </c:pt>
                <c:pt idx="211">
                  <c:v>6.1829562755512004</c:v>
                </c:pt>
                <c:pt idx="212">
                  <c:v>6.0864477876840199</c:v>
                </c:pt>
                <c:pt idx="213">
                  <c:v>6.5881664177938504</c:v>
                </c:pt>
                <c:pt idx="214">
                  <c:v>6.2635148205410003</c:v>
                </c:pt>
                <c:pt idx="215">
                  <c:v>5.3991307809914</c:v>
                </c:pt>
                <c:pt idx="216">
                  <c:v>6.1069542810456001</c:v>
                </c:pt>
                <c:pt idx="217">
                  <c:v>6.3098841528064904</c:v>
                </c:pt>
                <c:pt idx="218">
                  <c:v>5.86893426885546</c:v>
                </c:pt>
                <c:pt idx="219">
                  <c:v>5.8384725171910601</c:v>
                </c:pt>
                <c:pt idx="220">
                  <c:v>6.5988401912530597</c:v>
                </c:pt>
                <c:pt idx="221">
                  <c:v>6.0369042427402704</c:v>
                </c:pt>
                <c:pt idx="222">
                  <c:v>6.2297423365871403</c:v>
                </c:pt>
                <c:pt idx="223">
                  <c:v>6.0550755380982801</c:v>
                </c:pt>
                <c:pt idx="224">
                  <c:v>6.6472070273317501</c:v>
                </c:pt>
                <c:pt idx="225">
                  <c:v>6.7387038480090498</c:v>
                </c:pt>
                <c:pt idx="226">
                  <c:v>6.8072347851975898</c:v>
                </c:pt>
                <c:pt idx="227">
                  <c:v>6.8929121992532902</c:v>
                </c:pt>
                <c:pt idx="228">
                  <c:v>6.5618984075591804</c:v>
                </c:pt>
                <c:pt idx="229">
                  <c:v>6.7802843091812601</c:v>
                </c:pt>
                <c:pt idx="230">
                  <c:v>6.36702038132651</c:v>
                </c:pt>
                <c:pt idx="231">
                  <c:v>6.8140637407725997</c:v>
                </c:pt>
                <c:pt idx="232">
                  <c:v>7.13996181468836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0F0-7647-BA13-6BC01895FB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28809599"/>
        <c:axId val="1628811311"/>
      </c:scatterChart>
      <c:valAx>
        <c:axId val="162880959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28811311"/>
        <c:crosses val="autoZero"/>
        <c:crossBetween val="midCat"/>
      </c:valAx>
      <c:valAx>
        <c:axId val="162881131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288095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GAPIT.MLM.TimeMaturity.PRED'!$F$1</c:f>
              <c:strCache>
                <c:ptCount val="1"/>
                <c:pt idx="0">
                  <c:v>Prediction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8.491229221347342E-2"/>
                  <c:y val="-7.7774132400116658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</c:trendlineLbl>
          </c:trendline>
          <c:xVal>
            <c:numRef>
              <c:f>'GAPIT.MLM.TimeMaturity.PRED'!$E$2:$E$283</c:f>
              <c:numCache>
                <c:formatCode>General</c:formatCode>
                <c:ptCount val="282"/>
                <c:pt idx="0">
                  <c:v>9</c:v>
                </c:pt>
                <c:pt idx="1">
                  <c:v>9</c:v>
                </c:pt>
                <c:pt idx="2">
                  <c:v>9</c:v>
                </c:pt>
                <c:pt idx="3">
                  <c:v>9</c:v>
                </c:pt>
                <c:pt idx="4">
                  <c:v>9</c:v>
                </c:pt>
                <c:pt idx="5">
                  <c:v>9</c:v>
                </c:pt>
                <c:pt idx="6">
                  <c:v>9</c:v>
                </c:pt>
                <c:pt idx="7">
                  <c:v>9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8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8</c:v>
                </c:pt>
                <c:pt idx="17">
                  <c:v>8</c:v>
                </c:pt>
                <c:pt idx="18">
                  <c:v>8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8</c:v>
                </c:pt>
                <c:pt idx="24">
                  <c:v>7</c:v>
                </c:pt>
                <c:pt idx="25">
                  <c:v>7</c:v>
                </c:pt>
                <c:pt idx="26">
                  <c:v>7</c:v>
                </c:pt>
                <c:pt idx="27">
                  <c:v>7</c:v>
                </c:pt>
                <c:pt idx="28">
                  <c:v>7</c:v>
                </c:pt>
                <c:pt idx="29">
                  <c:v>7</c:v>
                </c:pt>
                <c:pt idx="30">
                  <c:v>7</c:v>
                </c:pt>
                <c:pt idx="31">
                  <c:v>7</c:v>
                </c:pt>
                <c:pt idx="32">
                  <c:v>7</c:v>
                </c:pt>
                <c:pt idx="33">
                  <c:v>7</c:v>
                </c:pt>
                <c:pt idx="34">
                  <c:v>7</c:v>
                </c:pt>
                <c:pt idx="35">
                  <c:v>7</c:v>
                </c:pt>
                <c:pt idx="36">
                  <c:v>7</c:v>
                </c:pt>
                <c:pt idx="37">
                  <c:v>7</c:v>
                </c:pt>
                <c:pt idx="38">
                  <c:v>7</c:v>
                </c:pt>
                <c:pt idx="39">
                  <c:v>7</c:v>
                </c:pt>
                <c:pt idx="40">
                  <c:v>7</c:v>
                </c:pt>
                <c:pt idx="41">
                  <c:v>7</c:v>
                </c:pt>
                <c:pt idx="42">
                  <c:v>7</c:v>
                </c:pt>
                <c:pt idx="43">
                  <c:v>7</c:v>
                </c:pt>
                <c:pt idx="44">
                  <c:v>7</c:v>
                </c:pt>
                <c:pt idx="45">
                  <c:v>7</c:v>
                </c:pt>
                <c:pt idx="46">
                  <c:v>7</c:v>
                </c:pt>
                <c:pt idx="47">
                  <c:v>7</c:v>
                </c:pt>
                <c:pt idx="48">
                  <c:v>7</c:v>
                </c:pt>
                <c:pt idx="49">
                  <c:v>7</c:v>
                </c:pt>
                <c:pt idx="50">
                  <c:v>7</c:v>
                </c:pt>
                <c:pt idx="51">
                  <c:v>7</c:v>
                </c:pt>
                <c:pt idx="52">
                  <c:v>7</c:v>
                </c:pt>
                <c:pt idx="53">
                  <c:v>7</c:v>
                </c:pt>
                <c:pt idx="54">
                  <c:v>7</c:v>
                </c:pt>
                <c:pt idx="55">
                  <c:v>7</c:v>
                </c:pt>
                <c:pt idx="56">
                  <c:v>7</c:v>
                </c:pt>
                <c:pt idx="57">
                  <c:v>7</c:v>
                </c:pt>
                <c:pt idx="58">
                  <c:v>7</c:v>
                </c:pt>
                <c:pt idx="59">
                  <c:v>7</c:v>
                </c:pt>
                <c:pt idx="60">
                  <c:v>7</c:v>
                </c:pt>
                <c:pt idx="61">
                  <c:v>7</c:v>
                </c:pt>
                <c:pt idx="62">
                  <c:v>7</c:v>
                </c:pt>
                <c:pt idx="63">
                  <c:v>7</c:v>
                </c:pt>
                <c:pt idx="64">
                  <c:v>7</c:v>
                </c:pt>
                <c:pt idx="65">
                  <c:v>7</c:v>
                </c:pt>
                <c:pt idx="66">
                  <c:v>6</c:v>
                </c:pt>
                <c:pt idx="67">
                  <c:v>6</c:v>
                </c:pt>
                <c:pt idx="68">
                  <c:v>6</c:v>
                </c:pt>
                <c:pt idx="69">
                  <c:v>6</c:v>
                </c:pt>
                <c:pt idx="70">
                  <c:v>6</c:v>
                </c:pt>
                <c:pt idx="71">
                  <c:v>6</c:v>
                </c:pt>
                <c:pt idx="72">
                  <c:v>6</c:v>
                </c:pt>
                <c:pt idx="73">
                  <c:v>6</c:v>
                </c:pt>
                <c:pt idx="74">
                  <c:v>6</c:v>
                </c:pt>
                <c:pt idx="75">
                  <c:v>6</c:v>
                </c:pt>
                <c:pt idx="76">
                  <c:v>6</c:v>
                </c:pt>
                <c:pt idx="77">
                  <c:v>6</c:v>
                </c:pt>
                <c:pt idx="78">
                  <c:v>6</c:v>
                </c:pt>
                <c:pt idx="79">
                  <c:v>6</c:v>
                </c:pt>
                <c:pt idx="80">
                  <c:v>6</c:v>
                </c:pt>
                <c:pt idx="81">
                  <c:v>6</c:v>
                </c:pt>
                <c:pt idx="82">
                  <c:v>6</c:v>
                </c:pt>
                <c:pt idx="83">
                  <c:v>6</c:v>
                </c:pt>
                <c:pt idx="84">
                  <c:v>6</c:v>
                </c:pt>
                <c:pt idx="85">
                  <c:v>6</c:v>
                </c:pt>
                <c:pt idx="86">
                  <c:v>6</c:v>
                </c:pt>
                <c:pt idx="87">
                  <c:v>6</c:v>
                </c:pt>
                <c:pt idx="88">
                  <c:v>6</c:v>
                </c:pt>
                <c:pt idx="89">
                  <c:v>6</c:v>
                </c:pt>
                <c:pt idx="90">
                  <c:v>6</c:v>
                </c:pt>
                <c:pt idx="91">
                  <c:v>6</c:v>
                </c:pt>
                <c:pt idx="92">
                  <c:v>6</c:v>
                </c:pt>
                <c:pt idx="93">
                  <c:v>6</c:v>
                </c:pt>
                <c:pt idx="94">
                  <c:v>6</c:v>
                </c:pt>
                <c:pt idx="95">
                  <c:v>6</c:v>
                </c:pt>
                <c:pt idx="96">
                  <c:v>6</c:v>
                </c:pt>
                <c:pt idx="97">
                  <c:v>6</c:v>
                </c:pt>
                <c:pt idx="98">
                  <c:v>6</c:v>
                </c:pt>
                <c:pt idx="99">
                  <c:v>6</c:v>
                </c:pt>
                <c:pt idx="100">
                  <c:v>5</c:v>
                </c:pt>
                <c:pt idx="101">
                  <c:v>5</c:v>
                </c:pt>
                <c:pt idx="102">
                  <c:v>5</c:v>
                </c:pt>
                <c:pt idx="103">
                  <c:v>5</c:v>
                </c:pt>
                <c:pt idx="104">
                  <c:v>5</c:v>
                </c:pt>
                <c:pt idx="105">
                  <c:v>5</c:v>
                </c:pt>
                <c:pt idx="106">
                  <c:v>5</c:v>
                </c:pt>
                <c:pt idx="107">
                  <c:v>5</c:v>
                </c:pt>
                <c:pt idx="108">
                  <c:v>5</c:v>
                </c:pt>
                <c:pt idx="109">
                  <c:v>5</c:v>
                </c:pt>
                <c:pt idx="110">
                  <c:v>5</c:v>
                </c:pt>
                <c:pt idx="111">
                  <c:v>5</c:v>
                </c:pt>
                <c:pt idx="112">
                  <c:v>5</c:v>
                </c:pt>
                <c:pt idx="113">
                  <c:v>5</c:v>
                </c:pt>
                <c:pt idx="114">
                  <c:v>5</c:v>
                </c:pt>
                <c:pt idx="115">
                  <c:v>5</c:v>
                </c:pt>
                <c:pt idx="116">
                  <c:v>5</c:v>
                </c:pt>
                <c:pt idx="117">
                  <c:v>5</c:v>
                </c:pt>
                <c:pt idx="118">
                  <c:v>5</c:v>
                </c:pt>
                <c:pt idx="119">
                  <c:v>5</c:v>
                </c:pt>
                <c:pt idx="120">
                  <c:v>5</c:v>
                </c:pt>
                <c:pt idx="121">
                  <c:v>5</c:v>
                </c:pt>
                <c:pt idx="122">
                  <c:v>5</c:v>
                </c:pt>
                <c:pt idx="123">
                  <c:v>5</c:v>
                </c:pt>
                <c:pt idx="124">
                  <c:v>5</c:v>
                </c:pt>
                <c:pt idx="125">
                  <c:v>5</c:v>
                </c:pt>
                <c:pt idx="126">
                  <c:v>5</c:v>
                </c:pt>
                <c:pt idx="127">
                  <c:v>5</c:v>
                </c:pt>
                <c:pt idx="128">
                  <c:v>5</c:v>
                </c:pt>
                <c:pt idx="129">
                  <c:v>5</c:v>
                </c:pt>
                <c:pt idx="130">
                  <c:v>5</c:v>
                </c:pt>
                <c:pt idx="131">
                  <c:v>5</c:v>
                </c:pt>
                <c:pt idx="132">
                  <c:v>5</c:v>
                </c:pt>
                <c:pt idx="133">
                  <c:v>5</c:v>
                </c:pt>
                <c:pt idx="134">
                  <c:v>5</c:v>
                </c:pt>
                <c:pt idx="135">
                  <c:v>5</c:v>
                </c:pt>
                <c:pt idx="136">
                  <c:v>5</c:v>
                </c:pt>
                <c:pt idx="137">
                  <c:v>5</c:v>
                </c:pt>
                <c:pt idx="138">
                  <c:v>5</c:v>
                </c:pt>
                <c:pt idx="139">
                  <c:v>5</c:v>
                </c:pt>
                <c:pt idx="140">
                  <c:v>5</c:v>
                </c:pt>
                <c:pt idx="141">
                  <c:v>5</c:v>
                </c:pt>
                <c:pt idx="142">
                  <c:v>5</c:v>
                </c:pt>
                <c:pt idx="143">
                  <c:v>5</c:v>
                </c:pt>
                <c:pt idx="144">
                  <c:v>5</c:v>
                </c:pt>
                <c:pt idx="145">
                  <c:v>5</c:v>
                </c:pt>
                <c:pt idx="146">
                  <c:v>5</c:v>
                </c:pt>
                <c:pt idx="147">
                  <c:v>5</c:v>
                </c:pt>
                <c:pt idx="148">
                  <c:v>5</c:v>
                </c:pt>
                <c:pt idx="149">
                  <c:v>5</c:v>
                </c:pt>
                <c:pt idx="150">
                  <c:v>5</c:v>
                </c:pt>
                <c:pt idx="151">
                  <c:v>5</c:v>
                </c:pt>
                <c:pt idx="152">
                  <c:v>5</c:v>
                </c:pt>
                <c:pt idx="153">
                  <c:v>5</c:v>
                </c:pt>
                <c:pt idx="154">
                  <c:v>5</c:v>
                </c:pt>
                <c:pt idx="155">
                  <c:v>5</c:v>
                </c:pt>
                <c:pt idx="156">
                  <c:v>5</c:v>
                </c:pt>
                <c:pt idx="157">
                  <c:v>5</c:v>
                </c:pt>
                <c:pt idx="158">
                  <c:v>5</c:v>
                </c:pt>
                <c:pt idx="159">
                  <c:v>5</c:v>
                </c:pt>
                <c:pt idx="160">
                  <c:v>5</c:v>
                </c:pt>
                <c:pt idx="161">
                  <c:v>5</c:v>
                </c:pt>
                <c:pt idx="162">
                  <c:v>5</c:v>
                </c:pt>
                <c:pt idx="163">
                  <c:v>5</c:v>
                </c:pt>
                <c:pt idx="164">
                  <c:v>5</c:v>
                </c:pt>
                <c:pt idx="165">
                  <c:v>5</c:v>
                </c:pt>
                <c:pt idx="166">
                  <c:v>5</c:v>
                </c:pt>
                <c:pt idx="167">
                  <c:v>5</c:v>
                </c:pt>
                <c:pt idx="168">
                  <c:v>5</c:v>
                </c:pt>
                <c:pt idx="169">
                  <c:v>5</c:v>
                </c:pt>
                <c:pt idx="170">
                  <c:v>5</c:v>
                </c:pt>
                <c:pt idx="171">
                  <c:v>5</c:v>
                </c:pt>
                <c:pt idx="172">
                  <c:v>5</c:v>
                </c:pt>
                <c:pt idx="173">
                  <c:v>5</c:v>
                </c:pt>
                <c:pt idx="174">
                  <c:v>5</c:v>
                </c:pt>
                <c:pt idx="175">
                  <c:v>5</c:v>
                </c:pt>
                <c:pt idx="176">
                  <c:v>5</c:v>
                </c:pt>
                <c:pt idx="177">
                  <c:v>5</c:v>
                </c:pt>
                <c:pt idx="178">
                  <c:v>5</c:v>
                </c:pt>
                <c:pt idx="179">
                  <c:v>5</c:v>
                </c:pt>
                <c:pt idx="180">
                  <c:v>5</c:v>
                </c:pt>
                <c:pt idx="181">
                  <c:v>5</c:v>
                </c:pt>
                <c:pt idx="182">
                  <c:v>5</c:v>
                </c:pt>
                <c:pt idx="183">
                  <c:v>5</c:v>
                </c:pt>
                <c:pt idx="184">
                  <c:v>5</c:v>
                </c:pt>
                <c:pt idx="185">
                  <c:v>5</c:v>
                </c:pt>
                <c:pt idx="186">
                  <c:v>5</c:v>
                </c:pt>
                <c:pt idx="187">
                  <c:v>5</c:v>
                </c:pt>
                <c:pt idx="188">
                  <c:v>5</c:v>
                </c:pt>
                <c:pt idx="189">
                  <c:v>4</c:v>
                </c:pt>
                <c:pt idx="190">
                  <c:v>4</c:v>
                </c:pt>
                <c:pt idx="191">
                  <c:v>4</c:v>
                </c:pt>
                <c:pt idx="192">
                  <c:v>4</c:v>
                </c:pt>
                <c:pt idx="193">
                  <c:v>4</c:v>
                </c:pt>
                <c:pt idx="194">
                  <c:v>4</c:v>
                </c:pt>
                <c:pt idx="195">
                  <c:v>4</c:v>
                </c:pt>
                <c:pt idx="196">
                  <c:v>4</c:v>
                </c:pt>
                <c:pt idx="197">
                  <c:v>4</c:v>
                </c:pt>
                <c:pt idx="198">
                  <c:v>4</c:v>
                </c:pt>
                <c:pt idx="199">
                  <c:v>4</c:v>
                </c:pt>
                <c:pt idx="200">
                  <c:v>4</c:v>
                </c:pt>
                <c:pt idx="201">
                  <c:v>4</c:v>
                </c:pt>
                <c:pt idx="202">
                  <c:v>3</c:v>
                </c:pt>
                <c:pt idx="203">
                  <c:v>3</c:v>
                </c:pt>
                <c:pt idx="204">
                  <c:v>3</c:v>
                </c:pt>
                <c:pt idx="205">
                  <c:v>3</c:v>
                </c:pt>
                <c:pt idx="206">
                  <c:v>3</c:v>
                </c:pt>
                <c:pt idx="207">
                  <c:v>3</c:v>
                </c:pt>
                <c:pt idx="208">
                  <c:v>3</c:v>
                </c:pt>
                <c:pt idx="209">
                  <c:v>3</c:v>
                </c:pt>
                <c:pt idx="210">
                  <c:v>3</c:v>
                </c:pt>
                <c:pt idx="211">
                  <c:v>3</c:v>
                </c:pt>
                <c:pt idx="212">
                  <c:v>3</c:v>
                </c:pt>
                <c:pt idx="213">
                  <c:v>3</c:v>
                </c:pt>
                <c:pt idx="214">
                  <c:v>3</c:v>
                </c:pt>
                <c:pt idx="215">
                  <c:v>3</c:v>
                </c:pt>
                <c:pt idx="216">
                  <c:v>3</c:v>
                </c:pt>
                <c:pt idx="217">
                  <c:v>3</c:v>
                </c:pt>
                <c:pt idx="218">
                  <c:v>3</c:v>
                </c:pt>
                <c:pt idx="219">
                  <c:v>3</c:v>
                </c:pt>
                <c:pt idx="220">
                  <c:v>3</c:v>
                </c:pt>
                <c:pt idx="221">
                  <c:v>3</c:v>
                </c:pt>
                <c:pt idx="222">
                  <c:v>3</c:v>
                </c:pt>
                <c:pt idx="223">
                  <c:v>3</c:v>
                </c:pt>
                <c:pt idx="224">
                  <c:v>3</c:v>
                </c:pt>
                <c:pt idx="225">
                  <c:v>3</c:v>
                </c:pt>
                <c:pt idx="226">
                  <c:v>3</c:v>
                </c:pt>
                <c:pt idx="227">
                  <c:v>3</c:v>
                </c:pt>
                <c:pt idx="228">
                  <c:v>3</c:v>
                </c:pt>
                <c:pt idx="229">
                  <c:v>3</c:v>
                </c:pt>
                <c:pt idx="230">
                  <c:v>3</c:v>
                </c:pt>
                <c:pt idx="231">
                  <c:v>3</c:v>
                </c:pt>
                <c:pt idx="232">
                  <c:v>3</c:v>
                </c:pt>
                <c:pt idx="233">
                  <c:v>3</c:v>
                </c:pt>
                <c:pt idx="234">
                  <c:v>3</c:v>
                </c:pt>
                <c:pt idx="235">
                  <c:v>3</c:v>
                </c:pt>
                <c:pt idx="236">
                  <c:v>3</c:v>
                </c:pt>
                <c:pt idx="237">
                  <c:v>3</c:v>
                </c:pt>
                <c:pt idx="238">
                  <c:v>3</c:v>
                </c:pt>
                <c:pt idx="239">
                  <c:v>3</c:v>
                </c:pt>
                <c:pt idx="240">
                  <c:v>3</c:v>
                </c:pt>
                <c:pt idx="241">
                  <c:v>3</c:v>
                </c:pt>
                <c:pt idx="242">
                  <c:v>3</c:v>
                </c:pt>
                <c:pt idx="243">
                  <c:v>3</c:v>
                </c:pt>
                <c:pt idx="244">
                  <c:v>3</c:v>
                </c:pt>
                <c:pt idx="245">
                  <c:v>3</c:v>
                </c:pt>
                <c:pt idx="246">
                  <c:v>2</c:v>
                </c:pt>
                <c:pt idx="247">
                  <c:v>2</c:v>
                </c:pt>
                <c:pt idx="248">
                  <c:v>2</c:v>
                </c:pt>
                <c:pt idx="249">
                  <c:v>2</c:v>
                </c:pt>
                <c:pt idx="250">
                  <c:v>2</c:v>
                </c:pt>
                <c:pt idx="251">
                  <c:v>2</c:v>
                </c:pt>
                <c:pt idx="252">
                  <c:v>2</c:v>
                </c:pt>
                <c:pt idx="253">
                  <c:v>2</c:v>
                </c:pt>
                <c:pt idx="254">
                  <c:v>1</c:v>
                </c:pt>
                <c:pt idx="255">
                  <c:v>1</c:v>
                </c:pt>
                <c:pt idx="256">
                  <c:v>1</c:v>
                </c:pt>
                <c:pt idx="257">
                  <c:v>1</c:v>
                </c:pt>
                <c:pt idx="258">
                  <c:v>1</c:v>
                </c:pt>
                <c:pt idx="259">
                  <c:v>1</c:v>
                </c:pt>
                <c:pt idx="260">
                  <c:v>1</c:v>
                </c:pt>
                <c:pt idx="261">
                  <c:v>1</c:v>
                </c:pt>
              </c:numCache>
            </c:numRef>
          </c:xVal>
          <c:yVal>
            <c:numRef>
              <c:f>'GAPIT.MLM.TimeMaturity.PRED'!$F$2:$F$283</c:f>
              <c:numCache>
                <c:formatCode>General</c:formatCode>
                <c:ptCount val="282"/>
                <c:pt idx="0">
                  <c:v>7.11524849251549</c:v>
                </c:pt>
                <c:pt idx="1">
                  <c:v>7.67824368907368</c:v>
                </c:pt>
                <c:pt idx="2">
                  <c:v>6.8841724799447404</c:v>
                </c:pt>
                <c:pt idx="3">
                  <c:v>6.5138251890799603</c:v>
                </c:pt>
                <c:pt idx="4">
                  <c:v>6.6810938780814002</c:v>
                </c:pt>
                <c:pt idx="5">
                  <c:v>6.7392401678744998</c:v>
                </c:pt>
                <c:pt idx="6">
                  <c:v>7.1682332344762596</c:v>
                </c:pt>
                <c:pt idx="7">
                  <c:v>7.3852372637027504</c:v>
                </c:pt>
                <c:pt idx="8">
                  <c:v>6.8940171284716403</c:v>
                </c:pt>
                <c:pt idx="9">
                  <c:v>6.9131502897934904</c:v>
                </c:pt>
                <c:pt idx="10">
                  <c:v>6.1507690481376596</c:v>
                </c:pt>
                <c:pt idx="11">
                  <c:v>6.6527872151505596</c:v>
                </c:pt>
                <c:pt idx="12">
                  <c:v>6.3458950370807399</c:v>
                </c:pt>
                <c:pt idx="13">
                  <c:v>6.7165612634276899</c:v>
                </c:pt>
                <c:pt idx="14">
                  <c:v>5.45902223403347</c:v>
                </c:pt>
                <c:pt idx="15">
                  <c:v>6.6585990374958897</c:v>
                </c:pt>
                <c:pt idx="16">
                  <c:v>7.0056094863689502</c:v>
                </c:pt>
                <c:pt idx="17">
                  <c:v>6.7218826391473003</c:v>
                </c:pt>
                <c:pt idx="18">
                  <c:v>6.43892985002031</c:v>
                </c:pt>
                <c:pt idx="19">
                  <c:v>7.1424100130710801</c:v>
                </c:pt>
                <c:pt idx="20">
                  <c:v>7.2634767720314297</c:v>
                </c:pt>
                <c:pt idx="21">
                  <c:v>6.5127082251658397</c:v>
                </c:pt>
                <c:pt idx="22">
                  <c:v>6.5276430562580199</c:v>
                </c:pt>
                <c:pt idx="23">
                  <c:v>6.8742028715614696</c:v>
                </c:pt>
                <c:pt idx="24">
                  <c:v>5.4416217405986398</c:v>
                </c:pt>
                <c:pt idx="25">
                  <c:v>5.4836965009537897</c:v>
                </c:pt>
                <c:pt idx="26">
                  <c:v>5.8338423180149102</c:v>
                </c:pt>
                <c:pt idx="27">
                  <c:v>5.4142064164236396</c:v>
                </c:pt>
                <c:pt idx="28">
                  <c:v>6.4857979602096503</c:v>
                </c:pt>
                <c:pt idx="29">
                  <c:v>5.9274285076618902</c:v>
                </c:pt>
                <c:pt idx="30">
                  <c:v>6.2627142532074602</c:v>
                </c:pt>
                <c:pt idx="31">
                  <c:v>6.1730105384669898</c:v>
                </c:pt>
                <c:pt idx="32">
                  <c:v>6.3790910379346197</c:v>
                </c:pt>
                <c:pt idx="33">
                  <c:v>6.4063710330036301</c:v>
                </c:pt>
                <c:pt idx="34">
                  <c:v>6.25380866122409</c:v>
                </c:pt>
                <c:pt idx="35">
                  <c:v>6.1167570883579003</c:v>
                </c:pt>
                <c:pt idx="36">
                  <c:v>5.9662325489136601</c:v>
                </c:pt>
                <c:pt idx="37">
                  <c:v>5.6836050921044103</c:v>
                </c:pt>
                <c:pt idx="38">
                  <c:v>5.5065180421859399</c:v>
                </c:pt>
                <c:pt idx="39">
                  <c:v>5.5809537170693098</c:v>
                </c:pt>
                <c:pt idx="40">
                  <c:v>6.2927294115870396</c:v>
                </c:pt>
                <c:pt idx="41">
                  <c:v>6.2367690627659798</c:v>
                </c:pt>
                <c:pt idx="42">
                  <c:v>6.6705070932794799</c:v>
                </c:pt>
                <c:pt idx="43">
                  <c:v>6.5550333498007696</c:v>
                </c:pt>
                <c:pt idx="44">
                  <c:v>5.3677759267727998</c:v>
                </c:pt>
                <c:pt idx="45">
                  <c:v>6.8339407952219302</c:v>
                </c:pt>
                <c:pt idx="46">
                  <c:v>5.73594998158572</c:v>
                </c:pt>
                <c:pt idx="47">
                  <c:v>5.9175931662478503</c:v>
                </c:pt>
                <c:pt idx="48">
                  <c:v>6.6887003659174002</c:v>
                </c:pt>
                <c:pt idx="49">
                  <c:v>6.5516106586473901</c:v>
                </c:pt>
                <c:pt idx="50">
                  <c:v>6.0260563124492101</c:v>
                </c:pt>
                <c:pt idx="51">
                  <c:v>6.0940070893090601</c:v>
                </c:pt>
                <c:pt idx="52">
                  <c:v>6.6407732275689497</c:v>
                </c:pt>
                <c:pt idx="53">
                  <c:v>6.5283572935645902</c:v>
                </c:pt>
                <c:pt idx="54">
                  <c:v>6.2266462998001</c:v>
                </c:pt>
                <c:pt idx="55">
                  <c:v>6.2133390985759496</c:v>
                </c:pt>
                <c:pt idx="56">
                  <c:v>6.68156942891454</c:v>
                </c:pt>
                <c:pt idx="57">
                  <c:v>6.5501859200992101</c:v>
                </c:pt>
                <c:pt idx="58">
                  <c:v>5.7261926293373797</c:v>
                </c:pt>
                <c:pt idx="59">
                  <c:v>6.02158989146821</c:v>
                </c:pt>
                <c:pt idx="60">
                  <c:v>6.5283938750474002</c:v>
                </c:pt>
                <c:pt idx="61">
                  <c:v>5.82801829240685</c:v>
                </c:pt>
                <c:pt idx="62">
                  <c:v>6.5767325827841896</c:v>
                </c:pt>
                <c:pt idx="63">
                  <c:v>5.9123225761199798</c:v>
                </c:pt>
                <c:pt idx="64">
                  <c:v>6.3676970234854702</c:v>
                </c:pt>
                <c:pt idx="65">
                  <c:v>6.0444777130915996</c:v>
                </c:pt>
                <c:pt idx="66">
                  <c:v>5.2265771179341396</c:v>
                </c:pt>
                <c:pt idx="67">
                  <c:v>5.05280753721014</c:v>
                </c:pt>
                <c:pt idx="68">
                  <c:v>4.9457740150884604</c:v>
                </c:pt>
                <c:pt idx="69">
                  <c:v>5.7958319422622502</c:v>
                </c:pt>
                <c:pt idx="70">
                  <c:v>6.3057887679721203</c:v>
                </c:pt>
                <c:pt idx="71">
                  <c:v>5.8186260164676797</c:v>
                </c:pt>
                <c:pt idx="72">
                  <c:v>6.23153561892327</c:v>
                </c:pt>
                <c:pt idx="73">
                  <c:v>5.87456875867999</c:v>
                </c:pt>
                <c:pt idx="74">
                  <c:v>5.3203542111036803</c:v>
                </c:pt>
                <c:pt idx="75">
                  <c:v>5.88919356122629</c:v>
                </c:pt>
                <c:pt idx="76">
                  <c:v>5.6889630174881596</c:v>
                </c:pt>
                <c:pt idx="77">
                  <c:v>6.2721604310488202</c:v>
                </c:pt>
                <c:pt idx="78">
                  <c:v>6.0095761136677499</c:v>
                </c:pt>
                <c:pt idx="79">
                  <c:v>5.9892160735210496</c:v>
                </c:pt>
                <c:pt idx="80">
                  <c:v>5.9003564596691298</c:v>
                </c:pt>
                <c:pt idx="81">
                  <c:v>6.5220868566004597</c:v>
                </c:pt>
                <c:pt idx="82">
                  <c:v>5.8237106407973203</c:v>
                </c:pt>
                <c:pt idx="83">
                  <c:v>5.50700193813464</c:v>
                </c:pt>
                <c:pt idx="84">
                  <c:v>5.9712890070549598</c:v>
                </c:pt>
                <c:pt idx="85">
                  <c:v>6.2101137289221002</c:v>
                </c:pt>
                <c:pt idx="86">
                  <c:v>5.7238409459542199</c:v>
                </c:pt>
                <c:pt idx="87">
                  <c:v>6.09562694126996</c:v>
                </c:pt>
                <c:pt idx="88">
                  <c:v>5.1103525132350196</c:v>
                </c:pt>
                <c:pt idx="89">
                  <c:v>6.2054571785826997</c:v>
                </c:pt>
                <c:pt idx="90">
                  <c:v>6.27857174287566</c:v>
                </c:pt>
                <c:pt idx="91">
                  <c:v>5.7360851235085404</c:v>
                </c:pt>
                <c:pt idx="92">
                  <c:v>6.3762727938151196</c:v>
                </c:pt>
                <c:pt idx="93">
                  <c:v>6.0620056317202202</c:v>
                </c:pt>
                <c:pt idx="94">
                  <c:v>5.5343242173166196</c:v>
                </c:pt>
                <c:pt idx="95">
                  <c:v>6.3113246305256601</c:v>
                </c:pt>
                <c:pt idx="96">
                  <c:v>5.6410334037850696</c:v>
                </c:pt>
                <c:pt idx="97">
                  <c:v>5.7527608685862104</c:v>
                </c:pt>
                <c:pt idx="98">
                  <c:v>6.3950105242220197</c:v>
                </c:pt>
                <c:pt idx="99">
                  <c:v>6.2345554052333698</c:v>
                </c:pt>
                <c:pt idx="100">
                  <c:v>5.24958082249917</c:v>
                </c:pt>
                <c:pt idx="101">
                  <c:v>5.2039036701164099</c:v>
                </c:pt>
                <c:pt idx="102">
                  <c:v>5.0985025390372103</c:v>
                </c:pt>
                <c:pt idx="103">
                  <c:v>5.1677831553429598</c:v>
                </c:pt>
                <c:pt idx="104">
                  <c:v>5.2940987076257198</c:v>
                </c:pt>
                <c:pt idx="105">
                  <c:v>4.7404306661498303</c:v>
                </c:pt>
                <c:pt idx="106">
                  <c:v>5.2942861506325398</c:v>
                </c:pt>
                <c:pt idx="107">
                  <c:v>5.87858638108038</c:v>
                </c:pt>
                <c:pt idx="108">
                  <c:v>5.4672465620801001</c:v>
                </c:pt>
                <c:pt idx="109">
                  <c:v>4.5602169248519697</c:v>
                </c:pt>
                <c:pt idx="110">
                  <c:v>5.2245830959918198</c:v>
                </c:pt>
                <c:pt idx="111">
                  <c:v>5.0339639818742503</c:v>
                </c:pt>
                <c:pt idx="112">
                  <c:v>5.1292521036223899</c:v>
                </c:pt>
                <c:pt idx="113">
                  <c:v>4.8972021151488496</c:v>
                </c:pt>
                <c:pt idx="114">
                  <c:v>5.5250557856208697</c:v>
                </c:pt>
                <c:pt idx="115">
                  <c:v>4.9672597307360196</c:v>
                </c:pt>
                <c:pt idx="116">
                  <c:v>5.0794217866515901</c:v>
                </c:pt>
                <c:pt idx="117">
                  <c:v>5.5350891220304703</c:v>
                </c:pt>
                <c:pt idx="118">
                  <c:v>5.3434174862196304</c:v>
                </c:pt>
                <c:pt idx="119">
                  <c:v>5.2870567363101397</c:v>
                </c:pt>
                <c:pt idx="120">
                  <c:v>5.7574962872228799</c:v>
                </c:pt>
                <c:pt idx="121">
                  <c:v>5.3891842529869498</c:v>
                </c:pt>
                <c:pt idx="122">
                  <c:v>5.5546864236021198</c:v>
                </c:pt>
                <c:pt idx="123">
                  <c:v>4.9023083106611596</c:v>
                </c:pt>
                <c:pt idx="124">
                  <c:v>5.6814404051079004</c:v>
                </c:pt>
                <c:pt idx="125">
                  <c:v>5.5833706697492396</c:v>
                </c:pt>
                <c:pt idx="126">
                  <c:v>5.0536393961882604</c:v>
                </c:pt>
                <c:pt idx="127">
                  <c:v>5.9971559283492404</c:v>
                </c:pt>
                <c:pt idx="128">
                  <c:v>5.9561904062859696</c:v>
                </c:pt>
                <c:pt idx="129">
                  <c:v>5.3714959729125402</c:v>
                </c:pt>
                <c:pt idx="130">
                  <c:v>5.6382966592367803</c:v>
                </c:pt>
                <c:pt idx="131">
                  <c:v>5.1718801842642703</c:v>
                </c:pt>
                <c:pt idx="132">
                  <c:v>6.3284250094419399</c:v>
                </c:pt>
                <c:pt idx="133">
                  <c:v>5.9786459772181404</c:v>
                </c:pt>
                <c:pt idx="134">
                  <c:v>5.1043913023339904</c:v>
                </c:pt>
                <c:pt idx="135">
                  <c:v>5.4891270540809503</c:v>
                </c:pt>
                <c:pt idx="136">
                  <c:v>5.7051241088998497</c:v>
                </c:pt>
                <c:pt idx="137">
                  <c:v>6.4428757116913298</c:v>
                </c:pt>
                <c:pt idx="138">
                  <c:v>5.07268959426451</c:v>
                </c:pt>
                <c:pt idx="139">
                  <c:v>5.5864583777577304</c:v>
                </c:pt>
                <c:pt idx="140">
                  <c:v>5.21289446779884</c:v>
                </c:pt>
                <c:pt idx="141">
                  <c:v>5.8244721584634398</c:v>
                </c:pt>
                <c:pt idx="142">
                  <c:v>5.6241915725175202</c:v>
                </c:pt>
                <c:pt idx="143">
                  <c:v>5.3197570561174796</c:v>
                </c:pt>
                <c:pt idx="144">
                  <c:v>6.36350858200902</c:v>
                </c:pt>
                <c:pt idx="145">
                  <c:v>5.1274541933205899</c:v>
                </c:pt>
                <c:pt idx="146">
                  <c:v>6.0131557190364404</c:v>
                </c:pt>
                <c:pt idx="147">
                  <c:v>5.3143197050991198</c:v>
                </c:pt>
                <c:pt idx="148">
                  <c:v>5.2069862176893702</c:v>
                </c:pt>
                <c:pt idx="149">
                  <c:v>5.9737503848420399</c:v>
                </c:pt>
                <c:pt idx="150">
                  <c:v>5.6658164685962502</c:v>
                </c:pt>
                <c:pt idx="151">
                  <c:v>4.7599291927552096</c:v>
                </c:pt>
                <c:pt idx="152">
                  <c:v>4.9356288851264001</c:v>
                </c:pt>
                <c:pt idx="153">
                  <c:v>5.01751517814251</c:v>
                </c:pt>
                <c:pt idx="154">
                  <c:v>6.2592176456933801</c:v>
                </c:pt>
                <c:pt idx="155">
                  <c:v>4.7726896502529303</c:v>
                </c:pt>
                <c:pt idx="156">
                  <c:v>5.8780437396703</c:v>
                </c:pt>
                <c:pt idx="157">
                  <c:v>5.7383586249270104</c:v>
                </c:pt>
                <c:pt idx="158">
                  <c:v>5.5189028214857103</c:v>
                </c:pt>
                <c:pt idx="159">
                  <c:v>5.3866781248421196</c:v>
                </c:pt>
                <c:pt idx="160">
                  <c:v>5.1759563512779199</c:v>
                </c:pt>
                <c:pt idx="161">
                  <c:v>4.1576618620915804</c:v>
                </c:pt>
                <c:pt idx="162">
                  <c:v>5.8969628714384701</c:v>
                </c:pt>
                <c:pt idx="163">
                  <c:v>5.5598490246469403</c:v>
                </c:pt>
                <c:pt idx="164">
                  <c:v>5.3732491326204501</c:v>
                </c:pt>
                <c:pt idx="165">
                  <c:v>6.1323912419838802</c:v>
                </c:pt>
                <c:pt idx="166">
                  <c:v>5.5380733607302099</c:v>
                </c:pt>
                <c:pt idx="167">
                  <c:v>5.5667950143257201</c:v>
                </c:pt>
                <c:pt idx="168">
                  <c:v>4.7817989978855699</c:v>
                </c:pt>
                <c:pt idx="169">
                  <c:v>5.8125112280567803</c:v>
                </c:pt>
                <c:pt idx="170">
                  <c:v>6.0516643467656204</c:v>
                </c:pt>
                <c:pt idx="171">
                  <c:v>5.3445291802368899</c:v>
                </c:pt>
                <c:pt idx="172">
                  <c:v>5.3576154366268902</c:v>
                </c:pt>
                <c:pt idx="173">
                  <c:v>5.4121524920630604</c:v>
                </c:pt>
                <c:pt idx="174">
                  <c:v>6.1928617662533103</c:v>
                </c:pt>
                <c:pt idx="175">
                  <c:v>3.26722141445256</c:v>
                </c:pt>
                <c:pt idx="176">
                  <c:v>6.4028135539839903</c:v>
                </c:pt>
                <c:pt idx="177">
                  <c:v>5.5195898439427902</c:v>
                </c:pt>
                <c:pt idx="178">
                  <c:v>3.5776232509016599</c:v>
                </c:pt>
                <c:pt idx="179">
                  <c:v>5.4637894852596602</c:v>
                </c:pt>
                <c:pt idx="180">
                  <c:v>5.17036601905391</c:v>
                </c:pt>
                <c:pt idx="181">
                  <c:v>5.1679952261514197</c:v>
                </c:pt>
                <c:pt idx="182">
                  <c:v>5.1582750564000603</c:v>
                </c:pt>
                <c:pt idx="183">
                  <c:v>5.38421607368136</c:v>
                </c:pt>
                <c:pt idx="184">
                  <c:v>5.5426035869065498</c:v>
                </c:pt>
                <c:pt idx="185">
                  <c:v>5.3245293791326098</c:v>
                </c:pt>
                <c:pt idx="186">
                  <c:v>5.5614982871303402</c:v>
                </c:pt>
                <c:pt idx="187">
                  <c:v>5.7269178685456001</c:v>
                </c:pt>
                <c:pt idx="188">
                  <c:v>4.9101944289107804</c:v>
                </c:pt>
                <c:pt idx="189">
                  <c:v>4.5207807369486499</c:v>
                </c:pt>
                <c:pt idx="190">
                  <c:v>4.2864018915278299</c:v>
                </c:pt>
                <c:pt idx="191">
                  <c:v>3.9370465305037001</c:v>
                </c:pt>
                <c:pt idx="192">
                  <c:v>5.2589098196087498</c:v>
                </c:pt>
                <c:pt idx="193">
                  <c:v>4.8228903842241504</c:v>
                </c:pt>
                <c:pt idx="194">
                  <c:v>2.96103149536702</c:v>
                </c:pt>
                <c:pt idx="195">
                  <c:v>4.6753429525870702</c:v>
                </c:pt>
                <c:pt idx="196">
                  <c:v>3.0022662888734599</c:v>
                </c:pt>
                <c:pt idx="197">
                  <c:v>5.9719263704097498</c:v>
                </c:pt>
                <c:pt idx="198">
                  <c:v>2.8866722998422101</c:v>
                </c:pt>
                <c:pt idx="199">
                  <c:v>3.4900487618798901</c:v>
                </c:pt>
                <c:pt idx="200">
                  <c:v>5.5528667379652203</c:v>
                </c:pt>
                <c:pt idx="201">
                  <c:v>3.15762510467381</c:v>
                </c:pt>
                <c:pt idx="202">
                  <c:v>2.6138329371226301</c:v>
                </c:pt>
                <c:pt idx="203">
                  <c:v>2.8698053325347099</c:v>
                </c:pt>
                <c:pt idx="204">
                  <c:v>3.9609776742081499</c:v>
                </c:pt>
                <c:pt idx="205">
                  <c:v>4.2578114706547101</c:v>
                </c:pt>
                <c:pt idx="206">
                  <c:v>4.65741429517049</c:v>
                </c:pt>
                <c:pt idx="207">
                  <c:v>3.7866955813919301</c:v>
                </c:pt>
                <c:pt idx="208">
                  <c:v>2.7544301509321598</c:v>
                </c:pt>
                <c:pt idx="209">
                  <c:v>3.8428073172291599</c:v>
                </c:pt>
                <c:pt idx="210">
                  <c:v>2.8907799055197501</c:v>
                </c:pt>
                <c:pt idx="211">
                  <c:v>2.3799966104144401</c:v>
                </c:pt>
                <c:pt idx="212">
                  <c:v>2.2826858645382999</c:v>
                </c:pt>
                <c:pt idx="213">
                  <c:v>5.1452539862587798</c:v>
                </c:pt>
                <c:pt idx="214">
                  <c:v>4.6288332667251204</c:v>
                </c:pt>
                <c:pt idx="215">
                  <c:v>2.8251452432447501</c:v>
                </c:pt>
                <c:pt idx="216">
                  <c:v>3.3225849388345998</c:v>
                </c:pt>
                <c:pt idx="217">
                  <c:v>3.56208896423604</c:v>
                </c:pt>
                <c:pt idx="218">
                  <c:v>5.72554579638095</c:v>
                </c:pt>
                <c:pt idx="219">
                  <c:v>3.2271360260028699</c:v>
                </c:pt>
                <c:pt idx="220">
                  <c:v>3.2041828796831799</c:v>
                </c:pt>
                <c:pt idx="221">
                  <c:v>3.44974874823028</c:v>
                </c:pt>
                <c:pt idx="222">
                  <c:v>3.3212857330723899</c:v>
                </c:pt>
                <c:pt idx="223">
                  <c:v>4.2314575023557701</c:v>
                </c:pt>
                <c:pt idx="224">
                  <c:v>3.7913783403789099</c:v>
                </c:pt>
                <c:pt idx="225">
                  <c:v>4.7555352407766396</c:v>
                </c:pt>
                <c:pt idx="226">
                  <c:v>3.6370085433575299</c:v>
                </c:pt>
                <c:pt idx="227">
                  <c:v>3.7035890664440001</c:v>
                </c:pt>
                <c:pt idx="228">
                  <c:v>2.8388484017342099</c:v>
                </c:pt>
                <c:pt idx="229">
                  <c:v>4.1990733944907603</c:v>
                </c:pt>
                <c:pt idx="230">
                  <c:v>3.53921816805684</c:v>
                </c:pt>
                <c:pt idx="231">
                  <c:v>3.2491599794558099</c:v>
                </c:pt>
                <c:pt idx="232">
                  <c:v>2.7245509576848002</c:v>
                </c:pt>
                <c:pt idx="233">
                  <c:v>3.2183950488505899</c:v>
                </c:pt>
                <c:pt idx="234">
                  <c:v>2.9360270824018402</c:v>
                </c:pt>
                <c:pt idx="235">
                  <c:v>2.9548083797320901</c:v>
                </c:pt>
                <c:pt idx="236">
                  <c:v>2.7097631490212102</c:v>
                </c:pt>
                <c:pt idx="237">
                  <c:v>2.74254464229915</c:v>
                </c:pt>
                <c:pt idx="238">
                  <c:v>3.28033923257555</c:v>
                </c:pt>
                <c:pt idx="239">
                  <c:v>4.8129577356381104</c:v>
                </c:pt>
                <c:pt idx="240">
                  <c:v>2.5914627246704098</c:v>
                </c:pt>
                <c:pt idx="241">
                  <c:v>3.0127863564592898</c:v>
                </c:pt>
                <c:pt idx="242">
                  <c:v>3.1384584394906399</c:v>
                </c:pt>
                <c:pt idx="243">
                  <c:v>2.7108535623184098</c:v>
                </c:pt>
                <c:pt idx="244">
                  <c:v>3.0702413264715198</c:v>
                </c:pt>
                <c:pt idx="245">
                  <c:v>2.97133537458723</c:v>
                </c:pt>
                <c:pt idx="246">
                  <c:v>2.5037487395134601</c:v>
                </c:pt>
                <c:pt idx="247">
                  <c:v>3.4717404393571401</c:v>
                </c:pt>
                <c:pt idx="248">
                  <c:v>4.9415072769812101</c:v>
                </c:pt>
                <c:pt idx="249">
                  <c:v>2.6344639317738801</c:v>
                </c:pt>
                <c:pt idx="250">
                  <c:v>5.0203017257573599</c:v>
                </c:pt>
                <c:pt idx="251">
                  <c:v>2.5553750342375401</c:v>
                </c:pt>
                <c:pt idx="252">
                  <c:v>4.3813556051012501</c:v>
                </c:pt>
                <c:pt idx="253">
                  <c:v>2.1926492020429502</c:v>
                </c:pt>
                <c:pt idx="254">
                  <c:v>2.3543917146201401</c:v>
                </c:pt>
                <c:pt idx="255">
                  <c:v>1.8676640435221299</c:v>
                </c:pt>
                <c:pt idx="256">
                  <c:v>2.7325318143919701</c:v>
                </c:pt>
                <c:pt idx="257">
                  <c:v>1.9844308314161101</c:v>
                </c:pt>
                <c:pt idx="258">
                  <c:v>2.0910293302172098</c:v>
                </c:pt>
                <c:pt idx="259">
                  <c:v>1.8524620549783899</c:v>
                </c:pt>
                <c:pt idx="260">
                  <c:v>2.25152858814866</c:v>
                </c:pt>
                <c:pt idx="261">
                  <c:v>1.937042377625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FC6-D44A-AF87-3CA75BE174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77508479"/>
        <c:axId val="1190804975"/>
      </c:scatterChart>
      <c:valAx>
        <c:axId val="107750847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Time of maturit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90804975"/>
        <c:crosses val="autoZero"/>
        <c:crossBetween val="midCat"/>
      </c:valAx>
      <c:valAx>
        <c:axId val="119080497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edic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7750847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0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0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0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CF1F52-ADD3-4441-A28E-57AAA5907B1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E8EE77-341F-D447-9CCA-2E684F3584F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50057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E8EE77-341F-D447-9CCA-2E684F3584FF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68222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E8EE77-341F-D447-9CCA-2E684F3584FF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47313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E8EE77-341F-D447-9CCA-2E684F3584FF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10330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E8EE77-341F-D447-9CCA-2E684F3584FF}" type="slidenum">
              <a:rPr lang="fr-FR" smtClean="0"/>
              <a:t>6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99768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931AB9A-4E36-284C-9653-E02AC2FAD0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1552773-7221-654D-AC54-24796C0D3B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72FBBA-5CA0-2E46-B387-B58B9E06D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E3211C-C924-C44B-A421-EFE0E4DFA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71C86E9-C818-4542-A1F1-DF9B27168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107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AE3FD84-19E7-D048-B8BE-3EEFF5BADE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834C82D-ACA5-2F41-898C-40CC3A2776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9A7FDAE-9214-7C49-9A19-FAB4FFDB6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0AA6321-0373-0A49-9884-E58AF84818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004DD0E-B3F6-8244-95A2-5396F6836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2946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C412B3F-7048-8E43-984C-5AD2E2E850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AEF7F1D-903A-0C4D-A234-57EC4EFE4F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D0623B-5496-3847-9226-56D3C4E0C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DA4D299-535E-E24C-97DA-2F32B5ACC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FC2BAFC-DA27-1049-A253-D5FFB34B2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587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C798EC0-5513-4343-B6FF-9897CA27D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CCEC05F-7A3E-6A40-BA95-47BF62F77F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3F01CE0-E1EB-194E-AC95-509B3B515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AB01ED8-822D-9A46-BAA2-328CDC6F1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050D3CA-12FB-0B4B-A043-4C13F213A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4528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777642D-E235-6048-A473-AF48E35E1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5E09142-8584-9143-B57C-6DCCAD3301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A82291F-E2FE-AC4A-AC6D-1F7C9FFF3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FF5C88-F09C-AF45-8DE7-36A2E5659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271DEE6-A3F3-6E41-8633-21F7647C5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8173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902824-88E2-A64C-B2BC-89D804F1C9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D1DF2-EF52-4548-99EA-5D2EE049F6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469E1E0-DDFA-1B42-8297-95BC3A8FC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ECBC641-5996-464D-859B-9F1E92759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1D37F48-1C3C-0544-85D8-4CD32A8AE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D633D1E-5530-C74F-87B3-08628A7EB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5228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186641F-985E-994C-B868-9E4C6F108D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C3A6F76-7B9B-5249-9222-3F81AFB761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373537D-BA94-DA4F-8E17-483AA21100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8B5F6D9-6BD4-5C45-BCF7-F0D400BDB2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85F853EA-4C05-1C4F-BFED-22A3D22C91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A524F59F-49B1-1745-AD2D-836DD2E8F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B0668ED-6B5F-3F46-9F47-41A83843F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D1C5725C-330E-B247-AE26-08576BCAE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6493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C7B1997-F9CC-3D48-84C7-A1AF13F2F5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807770D-85AA-B04C-8C39-109DD20FC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6AB735F-E457-E642-B95E-C9A036BD3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4FE18D21-C163-0947-8390-3535BF8A6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8468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7533167-5E85-B644-836C-63E8AF019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2FFE2DA-ED83-1C48-ABFB-D44C10E2F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5202CAB-9196-4A4C-8139-7E3BC7305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5774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7FA645-FEC3-2B42-BE8C-B7971370F8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3144A60-49E4-014D-9089-3B47697D71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558436F-8F4D-334A-B50E-DF8F64971C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90A0F26-EA62-C747-8AD9-2580F9768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6DA2148-46AF-D546-BE46-6A0CE8E18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A5469F3-A1A4-CA4B-95AA-E2B62F638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8069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3C9B18-8750-0945-B763-B60B3A40F8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8251920C-6356-3B4B-B879-F25223790B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57945F1-8DD6-0A4C-8170-5F06C594EF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242C94B-5AB0-E44E-A384-B36124543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10761BB-1A1E-614C-8ABF-59E5D8835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26367E2-BB3B-D144-835B-CA8CD8E2E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968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DCB356D-C24B-9442-A308-FC688EBC8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0C666DE-E37B-1742-A50B-658B9F899D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7494BE4-73BD-6C45-96AB-EC2E8FBE56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98811-B836-224B-9324-54510D00A9A3}" type="datetimeFigureOut">
              <a:rPr lang="fr-FR" smtClean="0"/>
              <a:t>15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74A060B-5468-FF4D-BCC4-ADF638F023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E3D5E9C-81CF-DE4C-8616-CA3B6ED140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12132A-EFAA-3946-911E-F58EC34B9A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5575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5.xml"/><Relationship Id="rId4" Type="http://schemas.openxmlformats.org/officeDocument/2006/relationships/image" Target="../media/image9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7F283B75-BBFA-A786-A11F-FCD3D991FB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7000" y="-336034"/>
            <a:ext cx="6858000" cy="685800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D2755C6B-AD84-A104-41F2-F25B8D2DA344}"/>
              </a:ext>
            </a:extLst>
          </p:cNvPr>
          <p:cNvSpPr txBox="1"/>
          <p:nvPr/>
        </p:nvSpPr>
        <p:spPr>
          <a:xfrm>
            <a:off x="3876594" y="6337300"/>
            <a:ext cx="54419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Supp Figure 1 : </a:t>
            </a:r>
            <a:r>
              <a:rPr lang="fr-FR" dirty="0" err="1"/>
              <a:t>Correlation</a:t>
            </a:r>
            <a:r>
              <a:rPr lang="fr-FR" dirty="0"/>
              <a:t> matrix </a:t>
            </a:r>
            <a:r>
              <a:rPr lang="fr-FR" dirty="0" err="1"/>
              <a:t>among</a:t>
            </a:r>
            <a:r>
              <a:rPr lang="fr-FR" dirty="0"/>
              <a:t> the DUS traits </a:t>
            </a:r>
          </a:p>
        </p:txBody>
      </p:sp>
    </p:spTree>
    <p:extLst>
      <p:ext uri="{BB962C8B-B14F-4D97-AF65-F5344CB8AC3E}">
        <p14:creationId xmlns:p14="http://schemas.microsoft.com/office/powerpoint/2010/main" val="3631134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2354CCA-90AD-B0F2-D637-DE8FEB3FFA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20628" y="6003728"/>
            <a:ext cx="10515600" cy="758536"/>
          </a:xfrm>
        </p:spPr>
        <p:txBody>
          <a:bodyPr>
            <a:normAutofit/>
          </a:bodyPr>
          <a:lstStyle/>
          <a:p>
            <a:r>
              <a:rPr lang="fr-FR" sz="1800" dirty="0"/>
              <a:t>Supp figure 2: PCA </a:t>
            </a:r>
            <a:r>
              <a:rPr lang="fr-FR" sz="1800" dirty="0" err="1"/>
              <a:t>showing</a:t>
            </a:r>
            <a:r>
              <a:rPr lang="fr-FR" sz="1800" dirty="0"/>
              <a:t> the </a:t>
            </a:r>
            <a:r>
              <a:rPr lang="fr-FR" sz="1800" dirty="0" err="1"/>
              <a:t>diversity</a:t>
            </a:r>
            <a:r>
              <a:rPr lang="fr-FR" sz="1800" dirty="0"/>
              <a:t> of 281 </a:t>
            </a:r>
            <a:r>
              <a:rPr lang="fr-FR" sz="1800" dirty="0" err="1"/>
              <a:t>varieties</a:t>
            </a:r>
            <a:r>
              <a:rPr lang="fr-FR" sz="1800" dirty="0"/>
              <a:t> </a:t>
            </a:r>
            <a:r>
              <a:rPr lang="fr-FR" sz="1800" dirty="0" err="1"/>
              <a:t>based</a:t>
            </a:r>
            <a:r>
              <a:rPr lang="fr-FR" sz="1800" dirty="0"/>
              <a:t> on </a:t>
            </a:r>
            <a:r>
              <a:rPr lang="fr-FR" sz="1800" dirty="0" err="1"/>
              <a:t>their</a:t>
            </a:r>
            <a:r>
              <a:rPr lang="fr-FR" sz="1800" dirty="0"/>
              <a:t> DUS  </a:t>
            </a:r>
            <a:r>
              <a:rPr lang="fr-FR" sz="1800" dirty="0" err="1"/>
              <a:t>phenotypes</a:t>
            </a:r>
            <a:endParaRPr lang="fr-FR" sz="1800" dirty="0"/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201B88CB-0E1A-C856-5074-7BB3C0DFFE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60685" y="647210"/>
            <a:ext cx="7772400" cy="485775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B532EC7B-03DE-598F-E0AD-EB551B111A0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2626"/>
          <a:stretch/>
        </p:blipFill>
        <p:spPr>
          <a:xfrm>
            <a:off x="-695079" y="647210"/>
            <a:ext cx="6791079" cy="4857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07183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8835D4B5-FFB8-DFF5-A8C1-47E7C8DE41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6889" y="1813955"/>
            <a:ext cx="5168143" cy="323009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7122CF1F-F8F1-90FA-3B4C-B17DB1563507}"/>
              </a:ext>
            </a:extLst>
          </p:cNvPr>
          <p:cNvSpPr txBox="1"/>
          <p:nvPr/>
        </p:nvSpPr>
        <p:spPr>
          <a:xfrm>
            <a:off x="9640957" y="431358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E1E1806A-B036-0C9A-C131-9459511D3F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7409" y="1865440"/>
            <a:ext cx="5003390" cy="3127119"/>
          </a:xfrm>
          <a:prstGeom prst="rect">
            <a:avLst/>
          </a:prstGeom>
        </p:spPr>
      </p:pic>
      <p:sp>
        <p:nvSpPr>
          <p:cNvPr id="8" name="Titre 1">
            <a:extLst>
              <a:ext uri="{FF2B5EF4-FFF2-40B4-BE49-F238E27FC236}">
                <a16:creationId xmlns:a16="http://schemas.microsoft.com/office/drawing/2014/main" id="{B5EC6053-171F-D679-5E54-169EED03C2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00774" y="5531342"/>
            <a:ext cx="10515600" cy="706930"/>
          </a:xfrm>
        </p:spPr>
        <p:txBody>
          <a:bodyPr>
            <a:normAutofit/>
          </a:bodyPr>
          <a:lstStyle/>
          <a:p>
            <a:r>
              <a:rPr lang="fr-FR" sz="1800" dirty="0"/>
              <a:t>Supp </a:t>
            </a:r>
            <a:r>
              <a:rPr lang="fr-FR" sz="1800" dirty="0" err="1"/>
              <a:t>Fig</a:t>
            </a:r>
            <a:r>
              <a:rPr lang="fr-FR" sz="1800" dirty="0"/>
              <a:t> 3 Diversity of </a:t>
            </a:r>
            <a:r>
              <a:rPr lang="fr-FR" sz="1800" dirty="0" err="1"/>
              <a:t>phenotypes</a:t>
            </a:r>
            <a:r>
              <a:rPr lang="fr-FR" sz="1800" dirty="0"/>
              <a:t> </a:t>
            </a:r>
            <a:r>
              <a:rPr lang="fr-FR" sz="1800" dirty="0" err="1"/>
              <a:t>according</a:t>
            </a:r>
            <a:r>
              <a:rPr lang="fr-FR" sz="1800" dirty="0"/>
              <a:t> to </a:t>
            </a:r>
            <a:r>
              <a:rPr lang="fr-FR" sz="1800" dirty="0" err="1"/>
              <a:t>growth</a:t>
            </a:r>
            <a:r>
              <a:rPr lang="fr-FR" sz="1800" dirty="0"/>
              <a:t> type (</a:t>
            </a:r>
            <a:r>
              <a:rPr lang="fr-FR" sz="1800" dirty="0" err="1"/>
              <a:t>left</a:t>
            </a:r>
            <a:r>
              <a:rPr lang="fr-FR" sz="1800" dirty="0"/>
              <a:t>) and </a:t>
            </a:r>
            <a:r>
              <a:rPr lang="fr-FR" sz="1800" dirty="0" err="1"/>
              <a:t>period</a:t>
            </a:r>
            <a:r>
              <a:rPr lang="fr-FR" sz="1800" dirty="0"/>
              <a:t> (right)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D719BF26-293C-511F-3451-9F410C98F60E}"/>
              </a:ext>
            </a:extLst>
          </p:cNvPr>
          <p:cNvSpPr txBox="1"/>
          <p:nvPr/>
        </p:nvSpPr>
        <p:spPr>
          <a:xfrm>
            <a:off x="6742632" y="1813955"/>
            <a:ext cx="124425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dirty="0"/>
              <a:t>2000- 2025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FF6F8CB0-DC24-AD60-41B4-0946EE622BFB}"/>
              </a:ext>
            </a:extLst>
          </p:cNvPr>
          <p:cNvSpPr txBox="1"/>
          <p:nvPr/>
        </p:nvSpPr>
        <p:spPr>
          <a:xfrm>
            <a:off x="9894054" y="1813955"/>
            <a:ext cx="119135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dirty="0"/>
              <a:t>1980-2000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E2204A3F-9F21-A22B-DDB8-DE21813191EF}"/>
              </a:ext>
            </a:extLst>
          </p:cNvPr>
          <p:cNvSpPr txBox="1"/>
          <p:nvPr/>
        </p:nvSpPr>
        <p:spPr>
          <a:xfrm>
            <a:off x="10639792" y="2183287"/>
            <a:ext cx="132087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dirty="0" err="1"/>
              <a:t>Before</a:t>
            </a:r>
            <a:r>
              <a:rPr lang="fr-FR" dirty="0"/>
              <a:t> 1980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CD6B1D7E-8BEF-7B78-903E-A3C062316542}"/>
              </a:ext>
            </a:extLst>
          </p:cNvPr>
          <p:cNvSpPr txBox="1"/>
          <p:nvPr/>
        </p:nvSpPr>
        <p:spPr>
          <a:xfrm>
            <a:off x="917409" y="1593550"/>
            <a:ext cx="1283365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FR" sz="1600" dirty="0" err="1"/>
              <a:t>Determinate</a:t>
            </a:r>
            <a:r>
              <a:rPr lang="fr-FR" sz="1600" dirty="0"/>
              <a:t> </a:t>
            </a:r>
          </a:p>
          <a:p>
            <a:pPr algn="r"/>
            <a:r>
              <a:rPr lang="fr-FR" sz="1600" dirty="0" err="1"/>
              <a:t>growth</a:t>
            </a:r>
            <a:endParaRPr lang="fr-FR" sz="1600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29777091-DF4B-67A3-A8CE-C79E71FE4B03}"/>
              </a:ext>
            </a:extLst>
          </p:cNvPr>
          <p:cNvSpPr txBox="1"/>
          <p:nvPr/>
        </p:nvSpPr>
        <p:spPr>
          <a:xfrm>
            <a:off x="4303892" y="1593550"/>
            <a:ext cx="1422826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600" dirty="0" err="1"/>
              <a:t>Indeterminate</a:t>
            </a:r>
            <a:r>
              <a:rPr lang="fr-FR" sz="1600" dirty="0"/>
              <a:t> </a:t>
            </a:r>
          </a:p>
          <a:p>
            <a:r>
              <a:rPr lang="fr-FR" sz="1600" dirty="0" err="1"/>
              <a:t>growth</a:t>
            </a:r>
            <a:endParaRPr lang="fr-FR" sz="16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A5F88CD-4FD4-102C-2A46-CE71A99D9CAF}"/>
              </a:ext>
            </a:extLst>
          </p:cNvPr>
          <p:cNvSpPr/>
          <p:nvPr/>
        </p:nvSpPr>
        <p:spPr>
          <a:xfrm>
            <a:off x="5366759" y="3085032"/>
            <a:ext cx="487110" cy="6067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FFF2140-E5C4-988A-7162-F8EE091A8E10}"/>
              </a:ext>
            </a:extLst>
          </p:cNvPr>
          <p:cNvSpPr/>
          <p:nvPr/>
        </p:nvSpPr>
        <p:spPr>
          <a:xfrm>
            <a:off x="11056674" y="3122398"/>
            <a:ext cx="591244" cy="6067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1321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B5134E98-ED38-060C-B746-50DDE493F4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7550860"/>
              </p:ext>
            </p:extLst>
          </p:nvPr>
        </p:nvGraphicFramePr>
        <p:xfrm>
          <a:off x="-110224" y="1707030"/>
          <a:ext cx="4346389" cy="35661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2ED86FFE-B042-CEA0-6D3C-57502BDFC2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851867"/>
              </p:ext>
            </p:extLst>
          </p:nvPr>
        </p:nvGraphicFramePr>
        <p:xfrm>
          <a:off x="3938588" y="1889081"/>
          <a:ext cx="4125072" cy="34010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FDC2C16E-A162-33AE-B648-F3A5629963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3006781"/>
              </p:ext>
            </p:extLst>
          </p:nvPr>
        </p:nvGraphicFramePr>
        <p:xfrm>
          <a:off x="7724518" y="1872130"/>
          <a:ext cx="4761755" cy="34349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id="{6DEE4239-670F-790C-DE0E-7D43C24B26F7}"/>
              </a:ext>
            </a:extLst>
          </p:cNvPr>
          <p:cNvSpPr txBox="1"/>
          <p:nvPr/>
        </p:nvSpPr>
        <p:spPr>
          <a:xfrm>
            <a:off x="950062" y="5919151"/>
            <a:ext cx="10102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Supp figure 4 : </a:t>
            </a:r>
            <a:r>
              <a:rPr lang="en-US" dirty="0"/>
              <a:t>Distribution of He, MAF and missing data per chromosome according to registration period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414797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910DAC2D-F13A-2B9F-DA71-7860AB3C05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4990084"/>
              </p:ext>
            </p:extLst>
          </p:nvPr>
        </p:nvGraphicFramePr>
        <p:xfrm>
          <a:off x="3108325" y="73911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Image 5">
            <a:extLst>
              <a:ext uri="{FF2B5EF4-FFF2-40B4-BE49-F238E27FC236}">
                <a16:creationId xmlns:a16="http://schemas.microsoft.com/office/drawing/2014/main" id="{B8977392-1288-0AD9-C761-3BCD4439E6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310" y="3689349"/>
            <a:ext cx="5917720" cy="2661305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13732224-A239-C833-C6AB-E9B6F6638F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3551326"/>
            <a:ext cx="3168651" cy="3168651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A52162FB-9A14-69F7-6E7C-E9B3A45C3EF8}"/>
              </a:ext>
            </a:extLst>
          </p:cNvPr>
          <p:cNvSpPr txBox="1"/>
          <p:nvPr/>
        </p:nvSpPr>
        <p:spPr>
          <a:xfrm>
            <a:off x="2418248" y="300772"/>
            <a:ext cx="5869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Supp Figure 5a : </a:t>
            </a:r>
            <a:r>
              <a:rPr lang="fr-FR" dirty="0" err="1"/>
              <a:t>GWAs</a:t>
            </a:r>
            <a:r>
              <a:rPr lang="fr-FR" dirty="0"/>
              <a:t> and </a:t>
            </a:r>
            <a:r>
              <a:rPr lang="fr-FR" dirty="0" err="1"/>
              <a:t>prediction</a:t>
            </a:r>
            <a:r>
              <a:rPr lang="fr-FR" dirty="0"/>
              <a:t> </a:t>
            </a:r>
            <a:r>
              <a:rPr lang="fr-FR" dirty="0" err="1"/>
              <a:t>results</a:t>
            </a:r>
            <a:r>
              <a:rPr lang="fr-FR" dirty="0"/>
              <a:t> for Plant </a:t>
            </a:r>
            <a:r>
              <a:rPr lang="fr-FR" dirty="0" err="1"/>
              <a:t>Height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5298445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4B375877-C253-E690-D0D6-6D123E364E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88238" y="4278702"/>
            <a:ext cx="2143664" cy="2143664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71CBF04E-BEE5-4EF9-1D58-60DC996CB0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1102" y="3939516"/>
            <a:ext cx="7772400" cy="2482850"/>
          </a:xfrm>
          <a:prstGeom prst="rect">
            <a:avLst/>
          </a:prstGeom>
        </p:spPr>
      </p:pic>
      <p:graphicFrame>
        <p:nvGraphicFramePr>
          <p:cNvPr id="8" name="Graphique 7">
            <a:extLst>
              <a:ext uri="{FF2B5EF4-FFF2-40B4-BE49-F238E27FC236}">
                <a16:creationId xmlns:a16="http://schemas.microsoft.com/office/drawing/2014/main" id="{B9DCFAF1-601E-B366-93CA-7660E91823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8270158"/>
              </p:ext>
            </p:extLst>
          </p:nvPr>
        </p:nvGraphicFramePr>
        <p:xfrm>
          <a:off x="4116238" y="685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F0CFD248-4ABD-A699-465A-F6A7491F29A5}"/>
              </a:ext>
            </a:extLst>
          </p:cNvPr>
          <p:cNvSpPr txBox="1"/>
          <p:nvPr/>
        </p:nvSpPr>
        <p:spPr>
          <a:xfrm>
            <a:off x="2873558" y="316468"/>
            <a:ext cx="60947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dirty="0"/>
              <a:t>Supp Figure 5b : </a:t>
            </a:r>
            <a:r>
              <a:rPr lang="fr-FR" dirty="0" err="1"/>
              <a:t>GWAs</a:t>
            </a:r>
            <a:r>
              <a:rPr lang="fr-FR" dirty="0"/>
              <a:t> and </a:t>
            </a:r>
            <a:r>
              <a:rPr lang="fr-FR" dirty="0" err="1"/>
              <a:t>prediction</a:t>
            </a:r>
            <a:r>
              <a:rPr lang="fr-FR" dirty="0"/>
              <a:t> </a:t>
            </a:r>
            <a:r>
              <a:rPr lang="fr-FR" dirty="0" err="1"/>
              <a:t>results</a:t>
            </a:r>
            <a:r>
              <a:rPr lang="fr-FR" dirty="0"/>
              <a:t> for </a:t>
            </a:r>
            <a:r>
              <a:rPr lang="fr-FR" dirty="0" err="1"/>
              <a:t>Flowering</a:t>
            </a:r>
            <a:r>
              <a:rPr lang="fr-FR" dirty="0"/>
              <a:t> time </a:t>
            </a:r>
          </a:p>
        </p:txBody>
      </p:sp>
    </p:spTree>
    <p:extLst>
      <p:ext uri="{BB962C8B-B14F-4D97-AF65-F5344CB8AC3E}">
        <p14:creationId xmlns:p14="http://schemas.microsoft.com/office/powerpoint/2010/main" val="783954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E0B7FD51-B02A-4AB8-AAB7-01840CF919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27966"/>
            <a:ext cx="7772400" cy="248285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7D5617A7-C197-5B1F-CC8A-DD4B99ABDC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72400" y="3619500"/>
            <a:ext cx="2679700" cy="2679700"/>
          </a:xfrm>
          <a:prstGeom prst="rect">
            <a:avLst/>
          </a:prstGeom>
        </p:spPr>
      </p:pic>
      <p:graphicFrame>
        <p:nvGraphicFramePr>
          <p:cNvPr id="8" name="Graphique 7">
            <a:extLst>
              <a:ext uri="{FF2B5EF4-FFF2-40B4-BE49-F238E27FC236}">
                <a16:creationId xmlns:a16="http://schemas.microsoft.com/office/drawing/2014/main" id="{914B64AC-0840-828A-D8DB-810E1BFBBC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7966673"/>
              </p:ext>
            </p:extLst>
          </p:nvPr>
        </p:nvGraphicFramePr>
        <p:xfrm>
          <a:off x="3441700" y="87206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558F6C70-0562-2807-0CCF-405FEE15022A}"/>
              </a:ext>
            </a:extLst>
          </p:cNvPr>
          <p:cNvSpPr txBox="1"/>
          <p:nvPr/>
        </p:nvSpPr>
        <p:spPr>
          <a:xfrm>
            <a:off x="2828216" y="370889"/>
            <a:ext cx="690523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dirty="0"/>
              <a:t>Supp Figure 5c : </a:t>
            </a:r>
            <a:r>
              <a:rPr lang="fr-FR" dirty="0" err="1"/>
              <a:t>GWAs</a:t>
            </a:r>
            <a:r>
              <a:rPr lang="fr-FR" dirty="0"/>
              <a:t> and </a:t>
            </a:r>
            <a:r>
              <a:rPr lang="fr-FR" dirty="0" err="1"/>
              <a:t>prediction</a:t>
            </a:r>
            <a:r>
              <a:rPr lang="fr-FR" dirty="0"/>
              <a:t> </a:t>
            </a:r>
            <a:r>
              <a:rPr lang="fr-FR" dirty="0" err="1"/>
              <a:t>results</a:t>
            </a:r>
            <a:r>
              <a:rPr lang="fr-FR" dirty="0"/>
              <a:t> for Fruit </a:t>
            </a:r>
            <a:r>
              <a:rPr lang="fr-FR" dirty="0" err="1"/>
              <a:t>Maturity</a:t>
            </a:r>
            <a:r>
              <a:rPr lang="fr-FR" dirty="0"/>
              <a:t> time  </a:t>
            </a:r>
          </a:p>
        </p:txBody>
      </p:sp>
    </p:spTree>
    <p:extLst>
      <p:ext uri="{BB962C8B-B14F-4D97-AF65-F5344CB8AC3E}">
        <p14:creationId xmlns:p14="http://schemas.microsoft.com/office/powerpoint/2010/main" val="21149597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89</TotalTime>
  <Words>125</Words>
  <Application>Microsoft Macintosh PowerPoint</Application>
  <PresentationFormat>Grand écran</PresentationFormat>
  <Paragraphs>25</Paragraphs>
  <Slides>7</Slides>
  <Notes>4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hème Office</vt:lpstr>
      <vt:lpstr>Présentation PowerPoint</vt:lpstr>
      <vt:lpstr>Supp figure 2: PCA showing the diversity of 281 varieties based on their DUS  phenotypes</vt:lpstr>
      <vt:lpstr>Supp Fig 3 Diversity of phenotypes according to growth type (left) and period (right)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athilde Causse</cp:lastModifiedBy>
  <cp:revision>96</cp:revision>
  <cp:lastPrinted>2026-03-26T16:18:28Z</cp:lastPrinted>
  <dcterms:created xsi:type="dcterms:W3CDTF">2021-08-17T13:22:54Z</dcterms:created>
  <dcterms:modified xsi:type="dcterms:W3CDTF">2026-06-15T06:24:35Z</dcterms:modified>
</cp:coreProperties>
</file>